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7" r:id="rId2"/>
    <p:sldId id="260" r:id="rId3"/>
    <p:sldId id="267" r:id="rId4"/>
    <p:sldId id="269" r:id="rId5"/>
    <p:sldId id="261" r:id="rId6"/>
    <p:sldId id="263" r:id="rId7"/>
    <p:sldId id="271" r:id="rId8"/>
    <p:sldId id="302" r:id="rId9"/>
    <p:sldId id="303" r:id="rId10"/>
    <p:sldId id="304" r:id="rId11"/>
    <p:sldId id="305" r:id="rId12"/>
    <p:sldId id="306" r:id="rId13"/>
    <p:sldId id="307" r:id="rId14"/>
    <p:sldId id="308" r:id="rId15"/>
    <p:sldId id="309" r:id="rId16"/>
    <p:sldId id="310" r:id="rId17"/>
    <p:sldId id="311" r:id="rId18"/>
    <p:sldId id="312" r:id="rId19"/>
    <p:sldId id="313" r:id="rId20"/>
    <p:sldId id="318" r:id="rId21"/>
    <p:sldId id="319" r:id="rId22"/>
    <p:sldId id="320" r:id="rId23"/>
    <p:sldId id="275" r:id="rId24"/>
    <p:sldId id="277" r:id="rId25"/>
    <p:sldId id="279" r:id="rId26"/>
    <p:sldId id="276" r:id="rId27"/>
    <p:sldId id="278" r:id="rId2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92"/>
    <p:restoredTop sz="94646"/>
  </p:normalViewPr>
  <p:slideViewPr>
    <p:cSldViewPr snapToGrid="0">
      <p:cViewPr varScale="1">
        <p:scale>
          <a:sx n="81" d="100"/>
          <a:sy n="81" d="100"/>
        </p:scale>
        <p:origin x="154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Relationship Id="rId8" Type="http://schemas.openxmlformats.org/officeDocument/2006/relationships/slide" Target="slides/slide7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anxiao Chen" userId="138f6e53-1c63-40cd-bb43-399427c25ed2" providerId="ADAL" clId="{035F365E-B26C-4B0F-81B0-A41CCD7EED10}"/>
    <pc:docChg chg="undo custSel addSld delSld modSld sldOrd">
      <pc:chgData name="Tianxiao Chen" userId="138f6e53-1c63-40cd-bb43-399427c25ed2" providerId="ADAL" clId="{035F365E-B26C-4B0F-81B0-A41CCD7EED10}" dt="2020-04-18T01:28:08.921" v="388" actId="113"/>
      <pc:docMkLst>
        <pc:docMk/>
      </pc:docMkLst>
      <pc:sldChg chg="modSp">
        <pc:chgData name="Tianxiao Chen" userId="138f6e53-1c63-40cd-bb43-399427c25ed2" providerId="ADAL" clId="{035F365E-B26C-4B0F-81B0-A41CCD7EED10}" dt="2020-04-18T01:28:08.921" v="388" actId="113"/>
        <pc:sldMkLst>
          <pc:docMk/>
          <pc:sldMk cId="3864958779" sldId="256"/>
        </pc:sldMkLst>
        <pc:spChg chg="mod">
          <ac:chgData name="Tianxiao Chen" userId="138f6e53-1c63-40cd-bb43-399427c25ed2" providerId="ADAL" clId="{035F365E-B26C-4B0F-81B0-A41CCD7EED10}" dt="2020-04-18T01:28:08.921" v="388" actId="113"/>
          <ac:spMkLst>
            <pc:docMk/>
            <pc:sldMk cId="3864958779" sldId="256"/>
            <ac:spMk id="5" creationId="{4D5DDB36-F8AC-4ABE-B44A-B178673572EE}"/>
          </ac:spMkLst>
        </pc:spChg>
        <pc:picChg chg="mod">
          <ac:chgData name="Tianxiao Chen" userId="138f6e53-1c63-40cd-bb43-399427c25ed2" providerId="ADAL" clId="{035F365E-B26C-4B0F-81B0-A41CCD7EED10}" dt="2020-04-17T07:32:19.726" v="238" actId="1076"/>
          <ac:picMkLst>
            <pc:docMk/>
            <pc:sldMk cId="3864958779" sldId="256"/>
            <ac:picMk id="4" creationId="{CC9B3FDA-5522-4017-8031-D3E8D088544F}"/>
          </ac:picMkLst>
        </pc:picChg>
      </pc:sldChg>
      <pc:sldChg chg="del">
        <pc:chgData name="Tianxiao Chen" userId="138f6e53-1c63-40cd-bb43-399427c25ed2" providerId="ADAL" clId="{035F365E-B26C-4B0F-81B0-A41CCD7EED10}" dt="2020-04-17T07:39:52.291" v="260" actId="2696"/>
        <pc:sldMkLst>
          <pc:docMk/>
          <pc:sldMk cId="2784786649" sldId="264"/>
        </pc:sldMkLst>
      </pc:sldChg>
      <pc:sldChg chg="del">
        <pc:chgData name="Tianxiao Chen" userId="138f6e53-1c63-40cd-bb43-399427c25ed2" providerId="ADAL" clId="{035F365E-B26C-4B0F-81B0-A41CCD7EED10}" dt="2020-04-17T07:39:52.799" v="261" actId="2696"/>
        <pc:sldMkLst>
          <pc:docMk/>
          <pc:sldMk cId="1893780925" sldId="265"/>
        </pc:sldMkLst>
      </pc:sldChg>
      <pc:sldChg chg="addSp modSp">
        <pc:chgData name="Tianxiao Chen" userId="138f6e53-1c63-40cd-bb43-399427c25ed2" providerId="ADAL" clId="{035F365E-B26C-4B0F-81B0-A41CCD7EED10}" dt="2020-04-18T01:27:13.241" v="373" actId="403"/>
        <pc:sldMkLst>
          <pc:docMk/>
          <pc:sldMk cId="3985646919" sldId="275"/>
        </pc:sldMkLst>
        <pc:spChg chg="add mod">
          <ac:chgData name="Tianxiao Chen" userId="138f6e53-1c63-40cd-bb43-399427c25ed2" providerId="ADAL" clId="{035F365E-B26C-4B0F-81B0-A41CCD7EED10}" dt="2020-04-18T01:27:13.241" v="373" actId="403"/>
          <ac:spMkLst>
            <pc:docMk/>
            <pc:sldMk cId="3985646919" sldId="275"/>
            <ac:spMk id="3" creationId="{FA394CBC-B06F-4DB8-B6A7-53D41AD7373D}"/>
          </ac:spMkLst>
        </pc:spChg>
        <pc:picChg chg="add mod">
          <ac:chgData name="Tianxiao Chen" userId="138f6e53-1c63-40cd-bb43-399427c25ed2" providerId="ADAL" clId="{035F365E-B26C-4B0F-81B0-A41CCD7EED10}" dt="2020-04-14T06:40:27.474" v="4" actId="1076"/>
          <ac:picMkLst>
            <pc:docMk/>
            <pc:sldMk cId="3985646919" sldId="275"/>
            <ac:picMk id="2" creationId="{3EAB228B-B5BD-4A26-A22C-47EC52836EB8}"/>
          </ac:picMkLst>
        </pc:picChg>
      </pc:sldChg>
      <pc:sldChg chg="addSp modSp">
        <pc:chgData name="Tianxiao Chen" userId="138f6e53-1c63-40cd-bb43-399427c25ed2" providerId="ADAL" clId="{035F365E-B26C-4B0F-81B0-A41CCD7EED10}" dt="2020-04-18T01:27:02.711" v="370" actId="403"/>
        <pc:sldMkLst>
          <pc:docMk/>
          <pc:sldMk cId="2811834353" sldId="276"/>
        </pc:sldMkLst>
        <pc:spChg chg="add mod">
          <ac:chgData name="Tianxiao Chen" userId="138f6e53-1c63-40cd-bb43-399427c25ed2" providerId="ADAL" clId="{035F365E-B26C-4B0F-81B0-A41CCD7EED10}" dt="2020-04-18T01:27:02.711" v="370" actId="403"/>
          <ac:spMkLst>
            <pc:docMk/>
            <pc:sldMk cId="2811834353" sldId="276"/>
            <ac:spMk id="3" creationId="{C6F3FEFE-DC70-4534-802F-F411D3DE29A0}"/>
          </ac:spMkLst>
        </pc:spChg>
        <pc:picChg chg="add mod">
          <ac:chgData name="Tianxiao Chen" userId="138f6e53-1c63-40cd-bb43-399427c25ed2" providerId="ADAL" clId="{035F365E-B26C-4B0F-81B0-A41CCD7EED10}" dt="2020-04-14T23:32:07.303" v="92" actId="1076"/>
          <ac:picMkLst>
            <pc:docMk/>
            <pc:sldMk cId="2811834353" sldId="276"/>
            <ac:picMk id="2" creationId="{8D2258FE-8816-44E5-BE8F-E78B4A8CF819}"/>
          </ac:picMkLst>
        </pc:picChg>
      </pc:sldChg>
      <pc:sldChg chg="addSp delSp modSp ord">
        <pc:chgData name="Tianxiao Chen" userId="138f6e53-1c63-40cd-bb43-399427c25ed2" providerId="ADAL" clId="{035F365E-B26C-4B0F-81B0-A41CCD7EED10}" dt="2020-04-18T01:27:10.111" v="372" actId="403"/>
        <pc:sldMkLst>
          <pc:docMk/>
          <pc:sldMk cId="696762302" sldId="277"/>
        </pc:sldMkLst>
        <pc:spChg chg="add del">
          <ac:chgData name="Tianxiao Chen" userId="138f6e53-1c63-40cd-bb43-399427c25ed2" providerId="ADAL" clId="{035F365E-B26C-4B0F-81B0-A41CCD7EED10}" dt="2020-04-14T23:31:55.807" v="88"/>
          <ac:spMkLst>
            <pc:docMk/>
            <pc:sldMk cId="696762302" sldId="277"/>
            <ac:spMk id="2" creationId="{0C9B3E7F-31FE-4395-B660-F6613986B85A}"/>
          </ac:spMkLst>
        </pc:spChg>
        <pc:spChg chg="add mod">
          <ac:chgData name="Tianxiao Chen" userId="138f6e53-1c63-40cd-bb43-399427c25ed2" providerId="ADAL" clId="{035F365E-B26C-4B0F-81B0-A41CCD7EED10}" dt="2020-04-18T01:27:10.111" v="372" actId="403"/>
          <ac:spMkLst>
            <pc:docMk/>
            <pc:sldMk cId="696762302" sldId="277"/>
            <ac:spMk id="4" creationId="{70B9B4AF-9B8C-434E-8FF3-A3019C9007BF}"/>
          </ac:spMkLst>
        </pc:spChg>
        <pc:picChg chg="add mod">
          <ac:chgData name="Tianxiao Chen" userId="138f6e53-1c63-40cd-bb43-399427c25ed2" providerId="ADAL" clId="{035F365E-B26C-4B0F-81B0-A41CCD7EED10}" dt="2020-04-14T23:39:51.680" v="108" actId="1076"/>
          <ac:picMkLst>
            <pc:docMk/>
            <pc:sldMk cId="696762302" sldId="277"/>
            <ac:picMk id="3" creationId="{E6462CC4-F65C-41F9-94D2-F436DA109608}"/>
          </ac:picMkLst>
        </pc:picChg>
      </pc:sldChg>
      <pc:sldChg chg="addSp modSp">
        <pc:chgData name="Tianxiao Chen" userId="138f6e53-1c63-40cd-bb43-399427c25ed2" providerId="ADAL" clId="{035F365E-B26C-4B0F-81B0-A41CCD7EED10}" dt="2020-04-18T01:26:56.011" v="369" actId="403"/>
        <pc:sldMkLst>
          <pc:docMk/>
          <pc:sldMk cId="225929496" sldId="278"/>
        </pc:sldMkLst>
        <pc:spChg chg="add mod">
          <ac:chgData name="Tianxiao Chen" userId="138f6e53-1c63-40cd-bb43-399427c25ed2" providerId="ADAL" clId="{035F365E-B26C-4B0F-81B0-A41CCD7EED10}" dt="2020-04-18T01:26:56.011" v="369" actId="403"/>
          <ac:spMkLst>
            <pc:docMk/>
            <pc:sldMk cId="225929496" sldId="278"/>
            <ac:spMk id="3" creationId="{AAB34F6C-7B82-4130-8BC5-8EF56D7A53DA}"/>
          </ac:spMkLst>
        </pc:spChg>
        <pc:picChg chg="add mod">
          <ac:chgData name="Tianxiao Chen" userId="138f6e53-1c63-40cd-bb43-399427c25ed2" providerId="ADAL" clId="{035F365E-B26C-4B0F-81B0-A41CCD7EED10}" dt="2020-04-14T23:46:17.994" v="150" actId="1076"/>
          <ac:picMkLst>
            <pc:docMk/>
            <pc:sldMk cId="225929496" sldId="278"/>
            <ac:picMk id="2" creationId="{D5508F63-B5DE-4BC4-A65B-BDD909DCB7C8}"/>
          </ac:picMkLst>
        </pc:picChg>
      </pc:sldChg>
      <pc:sldChg chg="addSp modSp ord">
        <pc:chgData name="Tianxiao Chen" userId="138f6e53-1c63-40cd-bb43-399427c25ed2" providerId="ADAL" clId="{035F365E-B26C-4B0F-81B0-A41CCD7EED10}" dt="2020-04-18T01:27:06.371" v="371" actId="403"/>
        <pc:sldMkLst>
          <pc:docMk/>
          <pc:sldMk cId="2798986350" sldId="279"/>
        </pc:sldMkLst>
        <pc:spChg chg="add mod">
          <ac:chgData name="Tianxiao Chen" userId="138f6e53-1c63-40cd-bb43-399427c25ed2" providerId="ADAL" clId="{035F365E-B26C-4B0F-81B0-A41CCD7EED10}" dt="2020-04-18T01:27:06.371" v="371" actId="403"/>
          <ac:spMkLst>
            <pc:docMk/>
            <pc:sldMk cId="2798986350" sldId="279"/>
            <ac:spMk id="3" creationId="{E3049AF8-F132-4099-8FD1-3F9D896A635D}"/>
          </ac:spMkLst>
        </pc:spChg>
        <pc:picChg chg="add mod">
          <ac:chgData name="Tianxiao Chen" userId="138f6e53-1c63-40cd-bb43-399427c25ed2" providerId="ADAL" clId="{035F365E-B26C-4B0F-81B0-A41CCD7EED10}" dt="2020-04-15T00:02:31.655" v="166" actId="1076"/>
          <ac:picMkLst>
            <pc:docMk/>
            <pc:sldMk cId="2798986350" sldId="279"/>
            <ac:picMk id="2" creationId="{9B731F7E-8C6A-4455-94FC-B41491E9650C}"/>
          </ac:picMkLst>
        </pc:picChg>
      </pc:sldChg>
      <pc:sldChg chg="addSp modSp">
        <pc:chgData name="Tianxiao Chen" userId="138f6e53-1c63-40cd-bb43-399427c25ed2" providerId="ADAL" clId="{035F365E-B26C-4B0F-81B0-A41CCD7EED10}" dt="2020-04-18T01:26:53.331" v="368" actId="403"/>
        <pc:sldMkLst>
          <pc:docMk/>
          <pc:sldMk cId="2971242854" sldId="280"/>
        </pc:sldMkLst>
        <pc:spChg chg="add mod">
          <ac:chgData name="Tianxiao Chen" userId="138f6e53-1c63-40cd-bb43-399427c25ed2" providerId="ADAL" clId="{035F365E-B26C-4B0F-81B0-A41CCD7EED10}" dt="2020-04-18T01:26:53.331" v="368" actId="403"/>
          <ac:spMkLst>
            <pc:docMk/>
            <pc:sldMk cId="2971242854" sldId="280"/>
            <ac:spMk id="3" creationId="{86DBE1A8-05F7-4983-AE9E-1DB7A5396CB6}"/>
          </ac:spMkLst>
        </pc:spChg>
        <pc:picChg chg="add mod">
          <ac:chgData name="Tianxiao Chen" userId="138f6e53-1c63-40cd-bb43-399427c25ed2" providerId="ADAL" clId="{035F365E-B26C-4B0F-81B0-A41CCD7EED10}" dt="2020-04-15T00:10:08.119" v="195" actId="1076"/>
          <ac:picMkLst>
            <pc:docMk/>
            <pc:sldMk cId="2971242854" sldId="280"/>
            <ac:picMk id="2" creationId="{850BB4EB-811E-4A39-BD5C-498B6CCE2BFE}"/>
          </ac:picMkLst>
        </pc:picChg>
      </pc:sldChg>
      <pc:sldChg chg="addSp modSp">
        <pc:chgData name="Tianxiao Chen" userId="138f6e53-1c63-40cd-bb43-399427c25ed2" providerId="ADAL" clId="{035F365E-B26C-4B0F-81B0-A41CCD7EED10}" dt="2020-04-18T01:26:49.951" v="367" actId="403"/>
        <pc:sldMkLst>
          <pc:docMk/>
          <pc:sldMk cId="2858326092" sldId="281"/>
        </pc:sldMkLst>
        <pc:spChg chg="add mod">
          <ac:chgData name="Tianxiao Chen" userId="138f6e53-1c63-40cd-bb43-399427c25ed2" providerId="ADAL" clId="{035F365E-B26C-4B0F-81B0-A41CCD7EED10}" dt="2020-04-18T01:26:49.951" v="367" actId="403"/>
          <ac:spMkLst>
            <pc:docMk/>
            <pc:sldMk cId="2858326092" sldId="281"/>
            <ac:spMk id="3" creationId="{7C05A1C5-0941-4E19-BCFF-D793FA1A1FBA}"/>
          </ac:spMkLst>
        </pc:spChg>
        <pc:picChg chg="add mod">
          <ac:chgData name="Tianxiao Chen" userId="138f6e53-1c63-40cd-bb43-399427c25ed2" providerId="ADAL" clId="{035F365E-B26C-4B0F-81B0-A41CCD7EED10}" dt="2020-04-18T01:26:19.011" v="354" actId="1076"/>
          <ac:picMkLst>
            <pc:docMk/>
            <pc:sldMk cId="2858326092" sldId="281"/>
            <ac:picMk id="2" creationId="{D97885A8-DF26-4AAC-B6F2-10A4578ACE7A}"/>
          </ac:picMkLst>
        </pc:picChg>
      </pc:sldChg>
      <pc:sldChg chg="del">
        <pc:chgData name="Tianxiao Chen" userId="138f6e53-1c63-40cd-bb43-399427c25ed2" providerId="ADAL" clId="{035F365E-B26C-4B0F-81B0-A41CCD7EED10}" dt="2020-04-17T07:39:45.406" v="240" actId="2696"/>
        <pc:sldMkLst>
          <pc:docMk/>
          <pc:sldMk cId="2323991863" sldId="282"/>
        </pc:sldMkLst>
      </pc:sldChg>
      <pc:sldChg chg="del">
        <pc:chgData name="Tianxiao Chen" userId="138f6e53-1c63-40cd-bb43-399427c25ed2" providerId="ADAL" clId="{035F365E-B26C-4B0F-81B0-A41CCD7EED10}" dt="2020-04-17T07:39:46.037" v="241" actId="2696"/>
        <pc:sldMkLst>
          <pc:docMk/>
          <pc:sldMk cId="2162341974" sldId="283"/>
        </pc:sldMkLst>
      </pc:sldChg>
      <pc:sldChg chg="del">
        <pc:chgData name="Tianxiao Chen" userId="138f6e53-1c63-40cd-bb43-399427c25ed2" providerId="ADAL" clId="{035F365E-B26C-4B0F-81B0-A41CCD7EED10}" dt="2020-04-17T07:39:46.321" v="242" actId="2696"/>
        <pc:sldMkLst>
          <pc:docMk/>
          <pc:sldMk cId="1978871610" sldId="284"/>
        </pc:sldMkLst>
      </pc:sldChg>
      <pc:sldChg chg="del">
        <pc:chgData name="Tianxiao Chen" userId="138f6e53-1c63-40cd-bb43-399427c25ed2" providerId="ADAL" clId="{035F365E-B26C-4B0F-81B0-A41CCD7EED10}" dt="2020-04-17T07:39:46.498" v="243" actId="2696"/>
        <pc:sldMkLst>
          <pc:docMk/>
          <pc:sldMk cId="3441411460" sldId="285"/>
        </pc:sldMkLst>
      </pc:sldChg>
      <pc:sldChg chg="del">
        <pc:chgData name="Tianxiao Chen" userId="138f6e53-1c63-40cd-bb43-399427c25ed2" providerId="ADAL" clId="{035F365E-B26C-4B0F-81B0-A41CCD7EED10}" dt="2020-04-17T07:39:46.656" v="244" actId="2696"/>
        <pc:sldMkLst>
          <pc:docMk/>
          <pc:sldMk cId="1356058401" sldId="286"/>
        </pc:sldMkLst>
      </pc:sldChg>
      <pc:sldChg chg="del">
        <pc:chgData name="Tianxiao Chen" userId="138f6e53-1c63-40cd-bb43-399427c25ed2" providerId="ADAL" clId="{035F365E-B26C-4B0F-81B0-A41CCD7EED10}" dt="2020-04-17T07:39:46.825" v="245" actId="2696"/>
        <pc:sldMkLst>
          <pc:docMk/>
          <pc:sldMk cId="2491100121" sldId="287"/>
        </pc:sldMkLst>
      </pc:sldChg>
      <pc:sldChg chg="del">
        <pc:chgData name="Tianxiao Chen" userId="138f6e53-1c63-40cd-bb43-399427c25ed2" providerId="ADAL" clId="{035F365E-B26C-4B0F-81B0-A41CCD7EED10}" dt="2020-04-17T07:39:47.300" v="246" actId="2696"/>
        <pc:sldMkLst>
          <pc:docMk/>
          <pc:sldMk cId="2169190557" sldId="288"/>
        </pc:sldMkLst>
      </pc:sldChg>
      <pc:sldChg chg="del">
        <pc:chgData name="Tianxiao Chen" userId="138f6e53-1c63-40cd-bb43-399427c25ed2" providerId="ADAL" clId="{035F365E-B26C-4B0F-81B0-A41CCD7EED10}" dt="2020-04-17T07:39:47.309" v="247" actId="2696"/>
        <pc:sldMkLst>
          <pc:docMk/>
          <pc:sldMk cId="3805972279" sldId="289"/>
        </pc:sldMkLst>
      </pc:sldChg>
      <pc:sldChg chg="del">
        <pc:chgData name="Tianxiao Chen" userId="138f6e53-1c63-40cd-bb43-399427c25ed2" providerId="ADAL" clId="{035F365E-B26C-4B0F-81B0-A41CCD7EED10}" dt="2020-04-17T07:39:47.479" v="248" actId="2696"/>
        <pc:sldMkLst>
          <pc:docMk/>
          <pc:sldMk cId="2655970978" sldId="290"/>
        </pc:sldMkLst>
      </pc:sldChg>
      <pc:sldChg chg="del">
        <pc:chgData name="Tianxiao Chen" userId="138f6e53-1c63-40cd-bb43-399427c25ed2" providerId="ADAL" clId="{035F365E-B26C-4B0F-81B0-A41CCD7EED10}" dt="2020-04-17T07:39:47.644" v="249" actId="2696"/>
        <pc:sldMkLst>
          <pc:docMk/>
          <pc:sldMk cId="3321148966" sldId="291"/>
        </pc:sldMkLst>
      </pc:sldChg>
      <pc:sldChg chg="del">
        <pc:chgData name="Tianxiao Chen" userId="138f6e53-1c63-40cd-bb43-399427c25ed2" providerId="ADAL" clId="{035F365E-B26C-4B0F-81B0-A41CCD7EED10}" dt="2020-04-17T07:39:48.044" v="250" actId="2696"/>
        <pc:sldMkLst>
          <pc:docMk/>
          <pc:sldMk cId="477768656" sldId="292"/>
        </pc:sldMkLst>
      </pc:sldChg>
      <pc:sldChg chg="del">
        <pc:chgData name="Tianxiao Chen" userId="138f6e53-1c63-40cd-bb43-399427c25ed2" providerId="ADAL" clId="{035F365E-B26C-4B0F-81B0-A41CCD7EED10}" dt="2020-04-17T07:39:48.556" v="251" actId="2696"/>
        <pc:sldMkLst>
          <pc:docMk/>
          <pc:sldMk cId="3695276430" sldId="293"/>
        </pc:sldMkLst>
      </pc:sldChg>
      <pc:sldChg chg="del">
        <pc:chgData name="Tianxiao Chen" userId="138f6e53-1c63-40cd-bb43-399427c25ed2" providerId="ADAL" clId="{035F365E-B26C-4B0F-81B0-A41CCD7EED10}" dt="2020-04-17T07:39:49.273" v="252" actId="2696"/>
        <pc:sldMkLst>
          <pc:docMk/>
          <pc:sldMk cId="2361615559" sldId="294"/>
        </pc:sldMkLst>
      </pc:sldChg>
      <pc:sldChg chg="del">
        <pc:chgData name="Tianxiao Chen" userId="138f6e53-1c63-40cd-bb43-399427c25ed2" providerId="ADAL" clId="{035F365E-B26C-4B0F-81B0-A41CCD7EED10}" dt="2020-04-17T07:39:49.598" v="253" actId="2696"/>
        <pc:sldMkLst>
          <pc:docMk/>
          <pc:sldMk cId="2012886817" sldId="295"/>
        </pc:sldMkLst>
      </pc:sldChg>
      <pc:sldChg chg="del">
        <pc:chgData name="Tianxiao Chen" userId="138f6e53-1c63-40cd-bb43-399427c25ed2" providerId="ADAL" clId="{035F365E-B26C-4B0F-81B0-A41CCD7EED10}" dt="2020-04-17T07:39:49.801" v="254" actId="2696"/>
        <pc:sldMkLst>
          <pc:docMk/>
          <pc:sldMk cId="3849886256" sldId="296"/>
        </pc:sldMkLst>
      </pc:sldChg>
      <pc:sldChg chg="del">
        <pc:chgData name="Tianxiao Chen" userId="138f6e53-1c63-40cd-bb43-399427c25ed2" providerId="ADAL" clId="{035F365E-B26C-4B0F-81B0-A41CCD7EED10}" dt="2020-04-17T07:39:50.187" v="255" actId="2696"/>
        <pc:sldMkLst>
          <pc:docMk/>
          <pc:sldMk cId="475144610" sldId="297"/>
        </pc:sldMkLst>
      </pc:sldChg>
      <pc:sldChg chg="del">
        <pc:chgData name="Tianxiao Chen" userId="138f6e53-1c63-40cd-bb43-399427c25ed2" providerId="ADAL" clId="{035F365E-B26C-4B0F-81B0-A41CCD7EED10}" dt="2020-04-17T07:39:50.884" v="256" actId="2696"/>
        <pc:sldMkLst>
          <pc:docMk/>
          <pc:sldMk cId="2239690838" sldId="298"/>
        </pc:sldMkLst>
      </pc:sldChg>
      <pc:sldChg chg="del">
        <pc:chgData name="Tianxiao Chen" userId="138f6e53-1c63-40cd-bb43-399427c25ed2" providerId="ADAL" clId="{035F365E-B26C-4B0F-81B0-A41CCD7EED10}" dt="2020-04-17T07:39:51.099" v="257" actId="2696"/>
        <pc:sldMkLst>
          <pc:docMk/>
          <pc:sldMk cId="789140645" sldId="299"/>
        </pc:sldMkLst>
      </pc:sldChg>
      <pc:sldChg chg="del">
        <pc:chgData name="Tianxiao Chen" userId="138f6e53-1c63-40cd-bb43-399427c25ed2" providerId="ADAL" clId="{035F365E-B26C-4B0F-81B0-A41CCD7EED10}" dt="2020-04-17T07:39:51.296" v="258" actId="2696"/>
        <pc:sldMkLst>
          <pc:docMk/>
          <pc:sldMk cId="3509467919" sldId="300"/>
        </pc:sldMkLst>
      </pc:sldChg>
      <pc:sldChg chg="del">
        <pc:chgData name="Tianxiao Chen" userId="138f6e53-1c63-40cd-bb43-399427c25ed2" providerId="ADAL" clId="{035F365E-B26C-4B0F-81B0-A41CCD7EED10}" dt="2020-04-17T07:39:51.527" v="259" actId="2696"/>
        <pc:sldMkLst>
          <pc:docMk/>
          <pc:sldMk cId="2234395015" sldId="301"/>
        </pc:sldMkLst>
      </pc:sldChg>
      <pc:sldChg chg="modSp">
        <pc:chgData name="Tianxiao Chen" userId="138f6e53-1c63-40cd-bb43-399427c25ed2" providerId="ADAL" clId="{035F365E-B26C-4B0F-81B0-A41CCD7EED10}" dt="2020-04-18T01:27:47.441" v="383" actId="1076"/>
        <pc:sldMkLst>
          <pc:docMk/>
          <pc:sldMk cId="1261872545" sldId="310"/>
        </pc:sldMkLst>
        <pc:spChg chg="mod">
          <ac:chgData name="Tianxiao Chen" userId="138f6e53-1c63-40cd-bb43-399427c25ed2" providerId="ADAL" clId="{035F365E-B26C-4B0F-81B0-A41CCD7EED10}" dt="2020-04-18T01:27:47.441" v="383" actId="1076"/>
          <ac:spMkLst>
            <pc:docMk/>
            <pc:sldMk cId="1261872545" sldId="310"/>
            <ac:spMk id="3" creationId="{B0D1FF84-23D9-4E85-915E-AEFAC4E62031}"/>
          </ac:spMkLst>
        </pc:spChg>
      </pc:sldChg>
      <pc:sldChg chg="modSp">
        <pc:chgData name="Tianxiao Chen" userId="138f6e53-1c63-40cd-bb43-399427c25ed2" providerId="ADAL" clId="{035F365E-B26C-4B0F-81B0-A41CCD7EED10}" dt="2020-04-18T01:27:38.055" v="380" actId="403"/>
        <pc:sldMkLst>
          <pc:docMk/>
          <pc:sldMk cId="1835483514" sldId="311"/>
        </pc:sldMkLst>
        <pc:spChg chg="mod">
          <ac:chgData name="Tianxiao Chen" userId="138f6e53-1c63-40cd-bb43-399427c25ed2" providerId="ADAL" clId="{035F365E-B26C-4B0F-81B0-A41CCD7EED10}" dt="2020-04-18T01:27:38.055" v="380" actId="403"/>
          <ac:spMkLst>
            <pc:docMk/>
            <pc:sldMk cId="1835483514" sldId="311"/>
            <ac:spMk id="3" creationId="{85FD69B7-1448-4F43-B3B1-2EB7743B8884}"/>
          </ac:spMkLst>
        </pc:spChg>
      </pc:sldChg>
      <pc:sldChg chg="modSp">
        <pc:chgData name="Tianxiao Chen" userId="138f6e53-1c63-40cd-bb43-399427c25ed2" providerId="ADAL" clId="{035F365E-B26C-4B0F-81B0-A41CCD7EED10}" dt="2020-04-18T01:27:32.321" v="379" actId="1076"/>
        <pc:sldMkLst>
          <pc:docMk/>
          <pc:sldMk cId="1268309648" sldId="312"/>
        </pc:sldMkLst>
        <pc:spChg chg="mod">
          <ac:chgData name="Tianxiao Chen" userId="138f6e53-1c63-40cd-bb43-399427c25ed2" providerId="ADAL" clId="{035F365E-B26C-4B0F-81B0-A41CCD7EED10}" dt="2020-04-18T01:27:32.321" v="379" actId="1076"/>
          <ac:spMkLst>
            <pc:docMk/>
            <pc:sldMk cId="1268309648" sldId="312"/>
            <ac:spMk id="3" creationId="{796C1D43-FC74-4184-9A46-A648B63C835D}"/>
          </ac:spMkLst>
        </pc:spChg>
      </pc:sldChg>
      <pc:sldChg chg="modSp">
        <pc:chgData name="Tianxiao Chen" userId="138f6e53-1c63-40cd-bb43-399427c25ed2" providerId="ADAL" clId="{035F365E-B26C-4B0F-81B0-A41CCD7EED10}" dt="2020-04-18T01:27:23.781" v="376" actId="1076"/>
        <pc:sldMkLst>
          <pc:docMk/>
          <pc:sldMk cId="2321765978" sldId="313"/>
        </pc:sldMkLst>
        <pc:spChg chg="mod">
          <ac:chgData name="Tianxiao Chen" userId="138f6e53-1c63-40cd-bb43-399427c25ed2" providerId="ADAL" clId="{035F365E-B26C-4B0F-81B0-A41CCD7EED10}" dt="2020-04-18T01:27:23.781" v="376" actId="1076"/>
          <ac:spMkLst>
            <pc:docMk/>
            <pc:sldMk cId="2321765978" sldId="313"/>
            <ac:spMk id="3" creationId="{941C3BDE-2875-4B55-B5F7-AAF242B0E6DB}"/>
          </ac:spMkLst>
        </pc:spChg>
      </pc:sldChg>
      <pc:sldChg chg="addSp delSp modSp add">
        <pc:chgData name="Tianxiao Chen" userId="138f6e53-1c63-40cd-bb43-399427c25ed2" providerId="ADAL" clId="{035F365E-B26C-4B0F-81B0-A41CCD7EED10}" dt="2020-04-18T01:26:46.561" v="366" actId="1076"/>
        <pc:sldMkLst>
          <pc:docMk/>
          <pc:sldMk cId="4008080670" sldId="314"/>
        </pc:sldMkLst>
        <pc:spChg chg="add del mod">
          <ac:chgData name="Tianxiao Chen" userId="138f6e53-1c63-40cd-bb43-399427c25ed2" providerId="ADAL" clId="{035F365E-B26C-4B0F-81B0-A41CCD7EED10}" dt="2020-04-18T01:09:11.888" v="275"/>
          <ac:spMkLst>
            <pc:docMk/>
            <pc:sldMk cId="4008080670" sldId="314"/>
            <ac:spMk id="3" creationId="{3612312E-2C70-4535-8BA2-F2197F0A3FC6}"/>
          </ac:spMkLst>
        </pc:spChg>
        <pc:spChg chg="add mod">
          <ac:chgData name="Tianxiao Chen" userId="138f6e53-1c63-40cd-bb43-399427c25ed2" providerId="ADAL" clId="{035F365E-B26C-4B0F-81B0-A41CCD7EED10}" dt="2020-04-18T01:26:46.561" v="366" actId="1076"/>
          <ac:spMkLst>
            <pc:docMk/>
            <pc:sldMk cId="4008080670" sldId="314"/>
            <ac:spMk id="4" creationId="{95E89DDC-D37B-4C8C-B1F9-201ED4325FE3}"/>
          </ac:spMkLst>
        </pc:spChg>
        <pc:picChg chg="add del mod">
          <ac:chgData name="Tianxiao Chen" userId="138f6e53-1c63-40cd-bb43-399427c25ed2" providerId="ADAL" clId="{035F365E-B26C-4B0F-81B0-A41CCD7EED10}" dt="2020-04-18T01:26:09.315" v="349" actId="478"/>
          <ac:picMkLst>
            <pc:docMk/>
            <pc:sldMk cId="4008080670" sldId="314"/>
            <ac:picMk id="2" creationId="{C9FCD5A4-A8B4-443B-B423-48CCD3B0F26C}"/>
          </ac:picMkLst>
        </pc:picChg>
        <pc:picChg chg="add mod">
          <ac:chgData name="Tianxiao Chen" userId="138f6e53-1c63-40cd-bb43-399427c25ed2" providerId="ADAL" clId="{035F365E-B26C-4B0F-81B0-A41CCD7EED10}" dt="2020-04-18T01:26:29.480" v="359" actId="1076"/>
          <ac:picMkLst>
            <pc:docMk/>
            <pc:sldMk cId="4008080670" sldId="314"/>
            <ac:picMk id="5" creationId="{05E9F13E-3E8D-42E4-BAD3-E9B59E5852FC}"/>
          </ac:picMkLst>
        </pc:picChg>
      </pc:sldChg>
    </pc:docChg>
  </pc:docChgLst>
  <pc:docChgLst>
    <pc:chgData name="Tianxiao" userId="138f6e53-1c63-40cd-bb43-399427c25ed2" providerId="ADAL" clId="{A8773628-DEB1-45C2-B77A-A6085D947177}"/>
    <pc:docChg chg="custSel modSld">
      <pc:chgData name="Tianxiao" userId="138f6e53-1c63-40cd-bb43-399427c25ed2" providerId="ADAL" clId="{A8773628-DEB1-45C2-B77A-A6085D947177}" dt="2020-10-07T11:38:42.068" v="2" actId="1076"/>
      <pc:docMkLst>
        <pc:docMk/>
      </pc:docMkLst>
      <pc:sldChg chg="addSp delSp modSp">
        <pc:chgData name="Tianxiao" userId="138f6e53-1c63-40cd-bb43-399427c25ed2" providerId="ADAL" clId="{A8773628-DEB1-45C2-B77A-A6085D947177}" dt="2020-10-07T11:38:42.068" v="2" actId="1076"/>
        <pc:sldMkLst>
          <pc:docMk/>
          <pc:sldMk cId="225929496" sldId="278"/>
        </pc:sldMkLst>
        <pc:picChg chg="del">
          <ac:chgData name="Tianxiao" userId="138f6e53-1c63-40cd-bb43-399427c25ed2" providerId="ADAL" clId="{A8773628-DEB1-45C2-B77A-A6085D947177}" dt="2020-10-07T11:37:58.282" v="0" actId="478"/>
          <ac:picMkLst>
            <pc:docMk/>
            <pc:sldMk cId="225929496" sldId="278"/>
            <ac:picMk id="3" creationId="{B75D52B5-F519-4679-9614-E489BA92DE1B}"/>
          </ac:picMkLst>
        </pc:picChg>
        <pc:picChg chg="add mod">
          <ac:chgData name="Tianxiao" userId="138f6e53-1c63-40cd-bb43-399427c25ed2" providerId="ADAL" clId="{A8773628-DEB1-45C2-B77A-A6085D947177}" dt="2020-10-07T11:38:42.068" v="2" actId="1076"/>
          <ac:picMkLst>
            <pc:docMk/>
            <pc:sldMk cId="225929496" sldId="278"/>
            <ac:picMk id="4" creationId="{A30B8EAA-7268-45D2-9917-8BDFF24B40B0}"/>
          </ac:picMkLst>
        </pc:picChg>
      </pc:sldChg>
    </pc:docChg>
  </pc:docChgLst>
  <pc:docChgLst>
    <pc:chgData name="Tianxiao Chen" userId="138f6e53-1c63-40cd-bb43-399427c25ed2" providerId="ADAL" clId="{17137878-62FB-49AC-8BA4-0FA00438D8DD}"/>
    <pc:docChg chg="modSld">
      <pc:chgData name="Tianxiao Chen" userId="138f6e53-1c63-40cd-bb43-399427c25ed2" providerId="ADAL" clId="{17137878-62FB-49AC-8BA4-0FA00438D8DD}" dt="2020-11-16T03:34:43.857" v="106" actId="20577"/>
      <pc:docMkLst>
        <pc:docMk/>
      </pc:docMkLst>
      <pc:sldChg chg="modSp">
        <pc:chgData name="Tianxiao Chen" userId="138f6e53-1c63-40cd-bb43-399427c25ed2" providerId="ADAL" clId="{17137878-62FB-49AC-8BA4-0FA00438D8DD}" dt="2020-11-13T06:26:41.317" v="18" actId="1076"/>
        <pc:sldMkLst>
          <pc:docMk/>
          <pc:sldMk cId="1357871536" sldId="260"/>
        </pc:sldMkLst>
        <pc:spChg chg="mod">
          <ac:chgData name="Tianxiao Chen" userId="138f6e53-1c63-40cd-bb43-399427c25ed2" providerId="ADAL" clId="{17137878-62FB-49AC-8BA4-0FA00438D8DD}" dt="2020-11-13T06:26:41.317" v="18" actId="1076"/>
          <ac:spMkLst>
            <pc:docMk/>
            <pc:sldMk cId="1357871536" sldId="260"/>
            <ac:spMk id="3" creationId="{DF5E3B78-AFA9-486C-A964-49CDCB638380}"/>
          </ac:spMkLst>
        </pc:spChg>
      </pc:sldChg>
      <pc:sldChg chg="modSp">
        <pc:chgData name="Tianxiao Chen" userId="138f6e53-1c63-40cd-bb43-399427c25ed2" providerId="ADAL" clId="{17137878-62FB-49AC-8BA4-0FA00438D8DD}" dt="2020-11-13T06:27:15.776" v="42" actId="20577"/>
        <pc:sldMkLst>
          <pc:docMk/>
          <pc:sldMk cId="999436868" sldId="261"/>
        </pc:sldMkLst>
        <pc:spChg chg="mod">
          <ac:chgData name="Tianxiao Chen" userId="138f6e53-1c63-40cd-bb43-399427c25ed2" providerId="ADAL" clId="{17137878-62FB-49AC-8BA4-0FA00438D8DD}" dt="2020-11-13T06:27:15.776" v="42" actId="20577"/>
          <ac:spMkLst>
            <pc:docMk/>
            <pc:sldMk cId="999436868" sldId="261"/>
            <ac:spMk id="3" creationId="{85FD69B7-1448-4F43-B3B1-2EB7743B8884}"/>
          </ac:spMkLst>
        </pc:spChg>
      </pc:sldChg>
      <pc:sldChg chg="modSp">
        <pc:chgData name="Tianxiao Chen" userId="138f6e53-1c63-40cd-bb43-399427c25ed2" providerId="ADAL" clId="{17137878-62FB-49AC-8BA4-0FA00438D8DD}" dt="2020-11-13T06:27:24.804" v="50" actId="20577"/>
        <pc:sldMkLst>
          <pc:docMk/>
          <pc:sldMk cId="113519139" sldId="263"/>
        </pc:sldMkLst>
        <pc:spChg chg="mod">
          <ac:chgData name="Tianxiao Chen" userId="138f6e53-1c63-40cd-bb43-399427c25ed2" providerId="ADAL" clId="{17137878-62FB-49AC-8BA4-0FA00438D8DD}" dt="2020-11-13T06:27:24.804" v="50" actId="20577"/>
          <ac:spMkLst>
            <pc:docMk/>
            <pc:sldMk cId="113519139" sldId="263"/>
            <ac:spMk id="3" creationId="{796C1D43-FC74-4184-9A46-A648B63C835D}"/>
          </ac:spMkLst>
        </pc:spChg>
      </pc:sldChg>
      <pc:sldChg chg="modSp">
        <pc:chgData name="Tianxiao Chen" userId="138f6e53-1c63-40cd-bb43-399427c25ed2" providerId="ADAL" clId="{17137878-62FB-49AC-8BA4-0FA00438D8DD}" dt="2020-11-16T03:33:34.853" v="65" actId="20577"/>
        <pc:sldMkLst>
          <pc:docMk/>
          <pc:sldMk cId="1315133414" sldId="267"/>
        </pc:sldMkLst>
        <pc:spChg chg="mod">
          <ac:chgData name="Tianxiao Chen" userId="138f6e53-1c63-40cd-bb43-399427c25ed2" providerId="ADAL" clId="{17137878-62FB-49AC-8BA4-0FA00438D8DD}" dt="2020-11-16T03:33:34.853" v="65" actId="20577"/>
          <ac:spMkLst>
            <pc:docMk/>
            <pc:sldMk cId="1315133414" sldId="267"/>
            <ac:spMk id="3" creationId="{59DCE731-2D78-43CA-B249-DDFF1D80EF2F}"/>
          </ac:spMkLst>
        </pc:spChg>
      </pc:sldChg>
      <pc:sldChg chg="modSp">
        <pc:chgData name="Tianxiao Chen" userId="138f6e53-1c63-40cd-bb43-399427c25ed2" providerId="ADAL" clId="{17137878-62FB-49AC-8BA4-0FA00438D8DD}" dt="2020-11-16T03:33:43.017" v="67" actId="20577"/>
        <pc:sldMkLst>
          <pc:docMk/>
          <pc:sldMk cId="2124286229" sldId="269"/>
        </pc:sldMkLst>
        <pc:spChg chg="mod">
          <ac:chgData name="Tianxiao Chen" userId="138f6e53-1c63-40cd-bb43-399427c25ed2" providerId="ADAL" clId="{17137878-62FB-49AC-8BA4-0FA00438D8DD}" dt="2020-11-16T03:33:43.017" v="67" actId="20577"/>
          <ac:spMkLst>
            <pc:docMk/>
            <pc:sldMk cId="2124286229" sldId="269"/>
            <ac:spMk id="3" creationId="{B0D1FF84-23D9-4E85-915E-AEFAC4E62031}"/>
          </ac:spMkLst>
        </pc:spChg>
      </pc:sldChg>
      <pc:sldChg chg="modSp">
        <pc:chgData name="Tianxiao Chen" userId="138f6e53-1c63-40cd-bb43-399427c25ed2" providerId="ADAL" clId="{17137878-62FB-49AC-8BA4-0FA00438D8DD}" dt="2020-11-13T06:27:34.149" v="51"/>
        <pc:sldMkLst>
          <pc:docMk/>
          <pc:sldMk cId="1473003688" sldId="271"/>
        </pc:sldMkLst>
        <pc:spChg chg="mod">
          <ac:chgData name="Tianxiao Chen" userId="138f6e53-1c63-40cd-bb43-399427c25ed2" providerId="ADAL" clId="{17137878-62FB-49AC-8BA4-0FA00438D8DD}" dt="2020-11-13T06:27:34.149" v="51"/>
          <ac:spMkLst>
            <pc:docMk/>
            <pc:sldMk cId="1473003688" sldId="271"/>
            <ac:spMk id="3" creationId="{941C3BDE-2875-4B55-B5F7-AAF242B0E6DB}"/>
          </ac:spMkLst>
        </pc:spChg>
      </pc:sldChg>
      <pc:sldChg chg="modSp">
        <pc:chgData name="Tianxiao Chen" userId="138f6e53-1c63-40cd-bb43-399427c25ed2" providerId="ADAL" clId="{17137878-62FB-49AC-8BA4-0FA00438D8DD}" dt="2020-11-16T03:34:03.128" v="77" actId="20577"/>
        <pc:sldMkLst>
          <pc:docMk/>
          <pc:sldMk cId="3226567726" sldId="302"/>
        </pc:sldMkLst>
        <pc:spChg chg="mod">
          <ac:chgData name="Tianxiao Chen" userId="138f6e53-1c63-40cd-bb43-399427c25ed2" providerId="ADAL" clId="{17137878-62FB-49AC-8BA4-0FA00438D8DD}" dt="2020-11-16T03:34:03.128" v="77" actId="20577"/>
          <ac:spMkLst>
            <pc:docMk/>
            <pc:sldMk cId="3226567726" sldId="302"/>
            <ac:spMk id="3" creationId="{DF5E3B78-AFA9-486C-A964-49CDCB638380}"/>
          </ac:spMkLst>
        </pc:spChg>
      </pc:sldChg>
      <pc:sldChg chg="modSp">
        <pc:chgData name="Tianxiao Chen" userId="138f6e53-1c63-40cd-bb43-399427c25ed2" providerId="ADAL" clId="{17137878-62FB-49AC-8BA4-0FA00438D8DD}" dt="2020-11-16T03:34:09.469" v="79" actId="20577"/>
        <pc:sldMkLst>
          <pc:docMk/>
          <pc:sldMk cId="21031507" sldId="303"/>
        </pc:sldMkLst>
        <pc:spChg chg="mod">
          <ac:chgData name="Tianxiao Chen" userId="138f6e53-1c63-40cd-bb43-399427c25ed2" providerId="ADAL" clId="{17137878-62FB-49AC-8BA4-0FA00438D8DD}" dt="2020-11-16T03:34:09.469" v="79" actId="20577"/>
          <ac:spMkLst>
            <pc:docMk/>
            <pc:sldMk cId="21031507" sldId="303"/>
            <ac:spMk id="3" creationId="{59DCE731-2D78-43CA-B249-DDFF1D80EF2F}"/>
          </ac:spMkLst>
        </pc:spChg>
      </pc:sldChg>
      <pc:sldChg chg="modSp">
        <pc:chgData name="Tianxiao Chen" userId="138f6e53-1c63-40cd-bb43-399427c25ed2" providerId="ADAL" clId="{17137878-62FB-49AC-8BA4-0FA00438D8DD}" dt="2020-11-16T03:34:14.191" v="85" actId="20577"/>
        <pc:sldMkLst>
          <pc:docMk/>
          <pc:sldMk cId="3011973943" sldId="304"/>
        </pc:sldMkLst>
        <pc:spChg chg="mod">
          <ac:chgData name="Tianxiao Chen" userId="138f6e53-1c63-40cd-bb43-399427c25ed2" providerId="ADAL" clId="{17137878-62FB-49AC-8BA4-0FA00438D8DD}" dt="2020-11-16T03:34:14.191" v="85" actId="20577"/>
          <ac:spMkLst>
            <pc:docMk/>
            <pc:sldMk cId="3011973943" sldId="304"/>
            <ac:spMk id="3" creationId="{B0D1FF84-23D9-4E85-915E-AEFAC4E62031}"/>
          </ac:spMkLst>
        </pc:spChg>
      </pc:sldChg>
      <pc:sldChg chg="modSp">
        <pc:chgData name="Tianxiao Chen" userId="138f6e53-1c63-40cd-bb43-399427c25ed2" providerId="ADAL" clId="{17137878-62FB-49AC-8BA4-0FA00438D8DD}" dt="2020-11-13T06:27:52.972" v="55"/>
        <pc:sldMkLst>
          <pc:docMk/>
          <pc:sldMk cId="1802490701" sldId="305"/>
        </pc:sldMkLst>
        <pc:spChg chg="mod">
          <ac:chgData name="Tianxiao Chen" userId="138f6e53-1c63-40cd-bb43-399427c25ed2" providerId="ADAL" clId="{17137878-62FB-49AC-8BA4-0FA00438D8DD}" dt="2020-11-13T06:27:52.972" v="55"/>
          <ac:spMkLst>
            <pc:docMk/>
            <pc:sldMk cId="1802490701" sldId="305"/>
            <ac:spMk id="3" creationId="{85FD69B7-1448-4F43-B3B1-2EB7743B8884}"/>
          </ac:spMkLst>
        </pc:spChg>
      </pc:sldChg>
      <pc:sldChg chg="modSp">
        <pc:chgData name="Tianxiao Chen" userId="138f6e53-1c63-40cd-bb43-399427c25ed2" providerId="ADAL" clId="{17137878-62FB-49AC-8BA4-0FA00438D8DD}" dt="2020-11-13T06:27:57.287" v="56"/>
        <pc:sldMkLst>
          <pc:docMk/>
          <pc:sldMk cId="917139151" sldId="306"/>
        </pc:sldMkLst>
        <pc:spChg chg="mod">
          <ac:chgData name="Tianxiao Chen" userId="138f6e53-1c63-40cd-bb43-399427c25ed2" providerId="ADAL" clId="{17137878-62FB-49AC-8BA4-0FA00438D8DD}" dt="2020-11-13T06:27:57.287" v="56"/>
          <ac:spMkLst>
            <pc:docMk/>
            <pc:sldMk cId="917139151" sldId="306"/>
            <ac:spMk id="3" creationId="{796C1D43-FC74-4184-9A46-A648B63C835D}"/>
          </ac:spMkLst>
        </pc:spChg>
      </pc:sldChg>
      <pc:sldChg chg="modSp">
        <pc:chgData name="Tianxiao Chen" userId="138f6e53-1c63-40cd-bb43-399427c25ed2" providerId="ADAL" clId="{17137878-62FB-49AC-8BA4-0FA00438D8DD}" dt="2020-11-13T06:28:01.524" v="57"/>
        <pc:sldMkLst>
          <pc:docMk/>
          <pc:sldMk cId="1400319436" sldId="307"/>
        </pc:sldMkLst>
        <pc:spChg chg="mod">
          <ac:chgData name="Tianxiao Chen" userId="138f6e53-1c63-40cd-bb43-399427c25ed2" providerId="ADAL" clId="{17137878-62FB-49AC-8BA4-0FA00438D8DD}" dt="2020-11-13T06:28:01.524" v="57"/>
          <ac:spMkLst>
            <pc:docMk/>
            <pc:sldMk cId="1400319436" sldId="307"/>
            <ac:spMk id="3" creationId="{941C3BDE-2875-4B55-B5F7-AAF242B0E6DB}"/>
          </ac:spMkLst>
        </pc:spChg>
      </pc:sldChg>
      <pc:sldChg chg="modSp">
        <pc:chgData name="Tianxiao Chen" userId="138f6e53-1c63-40cd-bb43-399427c25ed2" providerId="ADAL" clId="{17137878-62FB-49AC-8BA4-0FA00438D8DD}" dt="2020-11-16T03:34:32.216" v="95" actId="20577"/>
        <pc:sldMkLst>
          <pc:docMk/>
          <pc:sldMk cId="2651429919" sldId="308"/>
        </pc:sldMkLst>
        <pc:spChg chg="mod">
          <ac:chgData name="Tianxiao Chen" userId="138f6e53-1c63-40cd-bb43-399427c25ed2" providerId="ADAL" clId="{17137878-62FB-49AC-8BA4-0FA00438D8DD}" dt="2020-11-16T03:34:32.216" v="95" actId="20577"/>
          <ac:spMkLst>
            <pc:docMk/>
            <pc:sldMk cId="2651429919" sldId="308"/>
            <ac:spMk id="3" creationId="{DF5E3B78-AFA9-486C-A964-49CDCB638380}"/>
          </ac:spMkLst>
        </pc:spChg>
      </pc:sldChg>
      <pc:sldChg chg="modSp">
        <pc:chgData name="Tianxiao Chen" userId="138f6e53-1c63-40cd-bb43-399427c25ed2" providerId="ADAL" clId="{17137878-62FB-49AC-8BA4-0FA00438D8DD}" dt="2020-11-16T03:34:39.077" v="100" actId="20577"/>
        <pc:sldMkLst>
          <pc:docMk/>
          <pc:sldMk cId="6630285" sldId="309"/>
        </pc:sldMkLst>
        <pc:spChg chg="mod">
          <ac:chgData name="Tianxiao Chen" userId="138f6e53-1c63-40cd-bb43-399427c25ed2" providerId="ADAL" clId="{17137878-62FB-49AC-8BA4-0FA00438D8DD}" dt="2020-11-16T03:34:39.077" v="100" actId="20577"/>
          <ac:spMkLst>
            <pc:docMk/>
            <pc:sldMk cId="6630285" sldId="309"/>
            <ac:spMk id="3" creationId="{59DCE731-2D78-43CA-B249-DDFF1D80EF2F}"/>
          </ac:spMkLst>
        </pc:spChg>
      </pc:sldChg>
      <pc:sldChg chg="modSp">
        <pc:chgData name="Tianxiao Chen" userId="138f6e53-1c63-40cd-bb43-399427c25ed2" providerId="ADAL" clId="{17137878-62FB-49AC-8BA4-0FA00438D8DD}" dt="2020-11-16T03:34:43.857" v="106" actId="20577"/>
        <pc:sldMkLst>
          <pc:docMk/>
          <pc:sldMk cId="1261872545" sldId="310"/>
        </pc:sldMkLst>
        <pc:spChg chg="mod">
          <ac:chgData name="Tianxiao Chen" userId="138f6e53-1c63-40cd-bb43-399427c25ed2" providerId="ADAL" clId="{17137878-62FB-49AC-8BA4-0FA00438D8DD}" dt="2020-11-16T03:34:43.857" v="106" actId="20577"/>
          <ac:spMkLst>
            <pc:docMk/>
            <pc:sldMk cId="1261872545" sldId="310"/>
            <ac:spMk id="3" creationId="{B0D1FF84-23D9-4E85-915E-AEFAC4E62031}"/>
          </ac:spMkLst>
        </pc:spChg>
      </pc:sldChg>
      <pc:sldChg chg="modSp">
        <pc:chgData name="Tianxiao Chen" userId="138f6e53-1c63-40cd-bb43-399427c25ed2" providerId="ADAL" clId="{17137878-62FB-49AC-8BA4-0FA00438D8DD}" dt="2020-11-13T06:28:18.147" v="61"/>
        <pc:sldMkLst>
          <pc:docMk/>
          <pc:sldMk cId="1835483514" sldId="311"/>
        </pc:sldMkLst>
        <pc:spChg chg="mod">
          <ac:chgData name="Tianxiao Chen" userId="138f6e53-1c63-40cd-bb43-399427c25ed2" providerId="ADAL" clId="{17137878-62FB-49AC-8BA4-0FA00438D8DD}" dt="2020-11-13T06:28:18.147" v="61"/>
          <ac:spMkLst>
            <pc:docMk/>
            <pc:sldMk cId="1835483514" sldId="311"/>
            <ac:spMk id="3" creationId="{85FD69B7-1448-4F43-B3B1-2EB7743B8884}"/>
          </ac:spMkLst>
        </pc:spChg>
      </pc:sldChg>
      <pc:sldChg chg="modSp">
        <pc:chgData name="Tianxiao Chen" userId="138f6e53-1c63-40cd-bb43-399427c25ed2" providerId="ADAL" clId="{17137878-62FB-49AC-8BA4-0FA00438D8DD}" dt="2020-11-13T06:28:24.629" v="62"/>
        <pc:sldMkLst>
          <pc:docMk/>
          <pc:sldMk cId="1268309648" sldId="312"/>
        </pc:sldMkLst>
        <pc:spChg chg="mod">
          <ac:chgData name="Tianxiao Chen" userId="138f6e53-1c63-40cd-bb43-399427c25ed2" providerId="ADAL" clId="{17137878-62FB-49AC-8BA4-0FA00438D8DD}" dt="2020-11-13T06:28:24.629" v="62"/>
          <ac:spMkLst>
            <pc:docMk/>
            <pc:sldMk cId="1268309648" sldId="312"/>
            <ac:spMk id="3" creationId="{796C1D43-FC74-4184-9A46-A648B63C835D}"/>
          </ac:spMkLst>
        </pc:spChg>
      </pc:sldChg>
      <pc:sldChg chg="modSp">
        <pc:chgData name="Tianxiao Chen" userId="138f6e53-1c63-40cd-bb43-399427c25ed2" providerId="ADAL" clId="{17137878-62FB-49AC-8BA4-0FA00438D8DD}" dt="2020-11-13T06:28:32.298" v="63"/>
        <pc:sldMkLst>
          <pc:docMk/>
          <pc:sldMk cId="2321765978" sldId="313"/>
        </pc:sldMkLst>
        <pc:spChg chg="mod">
          <ac:chgData name="Tianxiao Chen" userId="138f6e53-1c63-40cd-bb43-399427c25ed2" providerId="ADAL" clId="{17137878-62FB-49AC-8BA4-0FA00438D8DD}" dt="2020-11-13T06:28:32.298" v="63"/>
          <ac:spMkLst>
            <pc:docMk/>
            <pc:sldMk cId="2321765978" sldId="313"/>
            <ac:spMk id="3" creationId="{941C3BDE-2875-4B55-B5F7-AAF242B0E6DB}"/>
          </ac:spMkLst>
        </pc:spChg>
      </pc:sldChg>
      <pc:sldChg chg="modSp">
        <pc:chgData name="Tianxiao Chen" userId="138f6e53-1c63-40cd-bb43-399427c25ed2" providerId="ADAL" clId="{17137878-62FB-49AC-8BA4-0FA00438D8DD}" dt="2020-11-13T06:26:15.851" v="6" actId="14100"/>
        <pc:sldMkLst>
          <pc:docMk/>
          <pc:sldMk cId="1051226122" sldId="317"/>
        </pc:sldMkLst>
        <pc:spChg chg="mod">
          <ac:chgData name="Tianxiao Chen" userId="138f6e53-1c63-40cd-bb43-399427c25ed2" providerId="ADAL" clId="{17137878-62FB-49AC-8BA4-0FA00438D8DD}" dt="2020-11-13T06:26:15.851" v="6" actId="14100"/>
          <ac:spMkLst>
            <pc:docMk/>
            <pc:sldMk cId="1051226122" sldId="317"/>
            <ac:spMk id="17" creationId="{46AD13E5-C8D8-471A-84EE-D68B9D35A0EE}"/>
          </ac:spMkLst>
        </pc:spChg>
      </pc:sldChg>
    </pc:docChg>
  </pc:docChgLst>
  <pc:docChgLst>
    <pc:chgData name="Tianxiao Chen" userId="138f6e53-1c63-40cd-bb43-399427c25ed2" providerId="ADAL" clId="{30353BFB-73B2-4E35-9FC5-E884B218CDD1}"/>
    <pc:docChg chg="undo custSel modSld">
      <pc:chgData name="Tianxiao Chen" userId="138f6e53-1c63-40cd-bb43-399427c25ed2" providerId="ADAL" clId="{30353BFB-73B2-4E35-9FC5-E884B218CDD1}" dt="2020-08-25T00:07:26.484" v="45" actId="1076"/>
      <pc:docMkLst>
        <pc:docMk/>
      </pc:docMkLst>
      <pc:sldChg chg="addSp delSp modSp">
        <pc:chgData name="Tianxiao Chen" userId="138f6e53-1c63-40cd-bb43-399427c25ed2" providerId="ADAL" clId="{30353BFB-73B2-4E35-9FC5-E884B218CDD1}" dt="2020-08-25T00:07:26.484" v="45" actId="1076"/>
        <pc:sldMkLst>
          <pc:docMk/>
          <pc:sldMk cId="3749242890" sldId="316"/>
        </pc:sldMkLst>
        <pc:spChg chg="add mod">
          <ac:chgData name="Tianxiao Chen" userId="138f6e53-1c63-40cd-bb43-399427c25ed2" providerId="ADAL" clId="{30353BFB-73B2-4E35-9FC5-E884B218CDD1}" dt="2020-08-25T00:07:07.052" v="39" actId="164"/>
          <ac:spMkLst>
            <pc:docMk/>
            <pc:sldMk cId="3749242890" sldId="316"/>
            <ac:spMk id="2" creationId="{BF68E588-982F-492C-935F-A941F4DD7F48}"/>
          </ac:spMkLst>
        </pc:spChg>
        <pc:spChg chg="add mod">
          <ac:chgData name="Tianxiao Chen" userId="138f6e53-1c63-40cd-bb43-399427c25ed2" providerId="ADAL" clId="{30353BFB-73B2-4E35-9FC5-E884B218CDD1}" dt="2020-08-25T00:07:07.052" v="39" actId="164"/>
          <ac:spMkLst>
            <pc:docMk/>
            <pc:sldMk cId="3749242890" sldId="316"/>
            <ac:spMk id="5" creationId="{6CB6C22C-38BB-4F16-B35D-39D7A8C21C5A}"/>
          </ac:spMkLst>
        </pc:spChg>
        <pc:spChg chg="add mod">
          <ac:chgData name="Tianxiao Chen" userId="138f6e53-1c63-40cd-bb43-399427c25ed2" providerId="ADAL" clId="{30353BFB-73B2-4E35-9FC5-E884B218CDD1}" dt="2020-08-25T00:07:07.052" v="39" actId="164"/>
          <ac:spMkLst>
            <pc:docMk/>
            <pc:sldMk cId="3749242890" sldId="316"/>
            <ac:spMk id="6" creationId="{DF75159D-D1F3-45D8-B2C7-CD0FE3D4BF4E}"/>
          </ac:spMkLst>
        </pc:spChg>
        <pc:grpChg chg="add del mod">
          <ac:chgData name="Tianxiao Chen" userId="138f6e53-1c63-40cd-bb43-399427c25ed2" providerId="ADAL" clId="{30353BFB-73B2-4E35-9FC5-E884B218CDD1}" dt="2020-08-25T00:07:19.190" v="42" actId="478"/>
          <ac:grpSpMkLst>
            <pc:docMk/>
            <pc:sldMk cId="3749242890" sldId="316"/>
            <ac:grpSpMk id="7" creationId="{E4DCE38D-FA3E-4527-885D-809AE3EBF518}"/>
          </ac:grpSpMkLst>
        </pc:grpChg>
        <pc:picChg chg="mod">
          <ac:chgData name="Tianxiao Chen" userId="138f6e53-1c63-40cd-bb43-399427c25ed2" providerId="ADAL" clId="{30353BFB-73B2-4E35-9FC5-E884B218CDD1}" dt="2020-08-25T00:07:07.052" v="39" actId="164"/>
          <ac:picMkLst>
            <pc:docMk/>
            <pc:sldMk cId="3749242890" sldId="316"/>
            <ac:picMk id="3" creationId="{F827466A-3D9C-4EFB-B301-BF69B7147AC7}"/>
          </ac:picMkLst>
        </pc:picChg>
        <pc:picChg chg="add mod ord">
          <ac:chgData name="Tianxiao Chen" userId="138f6e53-1c63-40cd-bb43-399427c25ed2" providerId="ADAL" clId="{30353BFB-73B2-4E35-9FC5-E884B218CDD1}" dt="2020-08-25T00:07:26.484" v="45" actId="1076"/>
          <ac:picMkLst>
            <pc:docMk/>
            <pc:sldMk cId="3749242890" sldId="316"/>
            <ac:picMk id="8" creationId="{095D13D6-6A1E-4233-8E7E-C29B2BBD4D8C}"/>
          </ac:picMkLst>
        </pc:picChg>
      </pc:sldChg>
    </pc:docChg>
  </pc:docChgLst>
  <pc:docChgLst>
    <pc:chgData name="Tianxiao Chen" userId="138f6e53-1c63-40cd-bb43-399427c25ed2" providerId="ADAL" clId="{14F3610B-3665-4991-B643-19EBC669A83D}"/>
    <pc:docChg chg="modSld">
      <pc:chgData name="Tianxiao Chen" userId="138f6e53-1c63-40cd-bb43-399427c25ed2" providerId="ADAL" clId="{14F3610B-3665-4991-B643-19EBC669A83D}" dt="2020-12-03T01:24:03.529" v="6" actId="947"/>
      <pc:docMkLst>
        <pc:docMk/>
      </pc:docMkLst>
      <pc:sldChg chg="modSp">
        <pc:chgData name="Tianxiao Chen" userId="138f6e53-1c63-40cd-bb43-399427c25ed2" providerId="ADAL" clId="{14F3610B-3665-4991-B643-19EBC669A83D}" dt="2020-12-03T01:24:03.529" v="6" actId="947"/>
        <pc:sldMkLst>
          <pc:docMk/>
          <pc:sldMk cId="1051226122" sldId="317"/>
        </pc:sldMkLst>
        <pc:spChg chg="mod">
          <ac:chgData name="Tianxiao Chen" userId="138f6e53-1c63-40cd-bb43-399427c25ed2" providerId="ADAL" clId="{14F3610B-3665-4991-B643-19EBC669A83D}" dt="2020-12-03T01:24:03.529" v="6" actId="947"/>
          <ac:spMkLst>
            <pc:docMk/>
            <pc:sldMk cId="1051226122" sldId="317"/>
            <ac:spMk id="17" creationId="{46AD13E5-C8D8-471A-84EE-D68B9D35A0EE}"/>
          </ac:spMkLst>
        </pc:spChg>
      </pc:sldChg>
    </pc:docChg>
  </pc:docChgLst>
  <pc:docChgLst>
    <pc:chgData name="Tianxiao Chen" userId="138f6e53-1c63-40cd-bb43-399427c25ed2" providerId="ADAL" clId="{A8773628-DEB1-45C2-B77A-A6085D947177}"/>
    <pc:docChg chg="undo custSel addSld delSld modSld">
      <pc:chgData name="Tianxiao Chen" userId="138f6e53-1c63-40cd-bb43-399427c25ed2" providerId="ADAL" clId="{A8773628-DEB1-45C2-B77A-A6085D947177}" dt="2020-10-17T12:46:51.182" v="93" actId="1076"/>
      <pc:docMkLst>
        <pc:docMk/>
      </pc:docMkLst>
      <pc:sldChg chg="addSp delSp modSp">
        <pc:chgData name="Tianxiao Chen" userId="138f6e53-1c63-40cd-bb43-399427c25ed2" providerId="ADAL" clId="{A8773628-DEB1-45C2-B77A-A6085D947177}" dt="2020-10-17T12:44:31.824" v="70" actId="1076"/>
        <pc:sldMkLst>
          <pc:docMk/>
          <pc:sldMk cId="3985646919" sldId="275"/>
        </pc:sldMkLst>
        <pc:spChg chg="del">
          <ac:chgData name="Tianxiao Chen" userId="138f6e53-1c63-40cd-bb43-399427c25ed2" providerId="ADAL" clId="{A8773628-DEB1-45C2-B77A-A6085D947177}" dt="2020-09-30T02:15:38.531" v="2" actId="478"/>
          <ac:spMkLst>
            <pc:docMk/>
            <pc:sldMk cId="3985646919" sldId="275"/>
            <ac:spMk id="3" creationId="{FA394CBC-B06F-4DB8-B6A7-53D41AD7373D}"/>
          </ac:spMkLst>
        </pc:spChg>
        <pc:spChg chg="mod">
          <ac:chgData name="Tianxiao Chen" userId="138f6e53-1c63-40cd-bb43-399427c25ed2" providerId="ADAL" clId="{A8773628-DEB1-45C2-B77A-A6085D947177}" dt="2020-10-17T12:44:28.875" v="69" actId="1036"/>
          <ac:spMkLst>
            <pc:docMk/>
            <pc:sldMk cId="3985646919" sldId="275"/>
            <ac:spMk id="4" creationId="{4F67D40D-C18F-4977-B5A2-0EEF4D5F4E2E}"/>
          </ac:spMkLst>
        </pc:spChg>
        <pc:graphicFrameChg chg="add del mod">
          <ac:chgData name="Tianxiao Chen" userId="138f6e53-1c63-40cd-bb43-399427c25ed2" providerId="ADAL" clId="{A8773628-DEB1-45C2-B77A-A6085D947177}" dt="2020-09-30T02:16:34.025" v="18" actId="478"/>
          <ac:graphicFrameMkLst>
            <pc:docMk/>
            <pc:sldMk cId="3985646919" sldId="275"/>
            <ac:graphicFrameMk id="4" creationId="{98B6C775-CAA3-4314-9B4A-5ABA33C27DBC}"/>
          </ac:graphicFrameMkLst>
        </pc:graphicFrameChg>
        <pc:picChg chg="del">
          <ac:chgData name="Tianxiao Chen" userId="138f6e53-1c63-40cd-bb43-399427c25ed2" providerId="ADAL" clId="{A8773628-DEB1-45C2-B77A-A6085D947177}" dt="2020-09-30T02:15:37.274" v="1" actId="478"/>
          <ac:picMkLst>
            <pc:docMk/>
            <pc:sldMk cId="3985646919" sldId="275"/>
            <ac:picMk id="2" creationId="{3EAB228B-B5BD-4A26-A22C-47EC52836EB8}"/>
          </ac:picMkLst>
        </pc:picChg>
        <pc:picChg chg="add del mod">
          <ac:chgData name="Tianxiao Chen" userId="138f6e53-1c63-40cd-bb43-399427c25ed2" providerId="ADAL" clId="{A8773628-DEB1-45C2-B77A-A6085D947177}" dt="2020-10-17T12:43:50.275" v="57" actId="478"/>
          <ac:picMkLst>
            <pc:docMk/>
            <pc:sldMk cId="3985646919" sldId="275"/>
            <ac:picMk id="3" creationId="{9E75035D-DDD7-443E-957F-76562AC3D866}"/>
          </ac:picMkLst>
        </pc:picChg>
        <pc:picChg chg="add mod">
          <ac:chgData name="Tianxiao Chen" userId="138f6e53-1c63-40cd-bb43-399427c25ed2" providerId="ADAL" clId="{A8773628-DEB1-45C2-B77A-A6085D947177}" dt="2020-10-17T12:44:31.824" v="70" actId="1076"/>
          <ac:picMkLst>
            <pc:docMk/>
            <pc:sldMk cId="3985646919" sldId="275"/>
            <ac:picMk id="5" creationId="{6FD43E63-74B1-4BF7-A338-8BB2D39E9262}"/>
          </ac:picMkLst>
        </pc:picChg>
        <pc:picChg chg="add del mod">
          <ac:chgData name="Tianxiao Chen" userId="138f6e53-1c63-40cd-bb43-399427c25ed2" providerId="ADAL" clId="{A8773628-DEB1-45C2-B77A-A6085D947177}" dt="2020-10-04T11:48:21.231" v="26" actId="478"/>
          <ac:picMkLst>
            <pc:docMk/>
            <pc:sldMk cId="3985646919" sldId="275"/>
            <ac:picMk id="6" creationId="{E8B210DD-9F1A-4991-966D-E1512084F8FC}"/>
          </ac:picMkLst>
        </pc:picChg>
      </pc:sldChg>
      <pc:sldChg chg="addSp delSp modSp">
        <pc:chgData name="Tianxiao Chen" userId="138f6e53-1c63-40cd-bb43-399427c25ed2" providerId="ADAL" clId="{A8773628-DEB1-45C2-B77A-A6085D947177}" dt="2020-10-17T12:46:28.600" v="87" actId="1076"/>
        <pc:sldMkLst>
          <pc:docMk/>
          <pc:sldMk cId="2811834353" sldId="276"/>
        </pc:sldMkLst>
        <pc:spChg chg="del">
          <ac:chgData name="Tianxiao Chen" userId="138f6e53-1c63-40cd-bb43-399427c25ed2" providerId="ADAL" clId="{A8773628-DEB1-45C2-B77A-A6085D947177}" dt="2020-09-30T02:15:47.080" v="8" actId="478"/>
          <ac:spMkLst>
            <pc:docMk/>
            <pc:sldMk cId="2811834353" sldId="276"/>
            <ac:spMk id="3" creationId="{C6F3FEFE-DC70-4534-802F-F411D3DE29A0}"/>
          </ac:spMkLst>
        </pc:spChg>
        <pc:picChg chg="del">
          <ac:chgData name="Tianxiao Chen" userId="138f6e53-1c63-40cd-bb43-399427c25ed2" providerId="ADAL" clId="{A8773628-DEB1-45C2-B77A-A6085D947177}" dt="2020-09-30T02:15:45.619" v="7" actId="478"/>
          <ac:picMkLst>
            <pc:docMk/>
            <pc:sldMk cId="2811834353" sldId="276"/>
            <ac:picMk id="2" creationId="{8D2258FE-8816-44E5-BE8F-E78B4A8CF819}"/>
          </ac:picMkLst>
        </pc:picChg>
        <pc:picChg chg="add del mod">
          <ac:chgData name="Tianxiao Chen" userId="138f6e53-1c63-40cd-bb43-399427c25ed2" providerId="ADAL" clId="{A8773628-DEB1-45C2-B77A-A6085D947177}" dt="2020-10-05T07:03:04.036" v="40" actId="478"/>
          <ac:picMkLst>
            <pc:docMk/>
            <pc:sldMk cId="2811834353" sldId="276"/>
            <ac:picMk id="3" creationId="{45B4C2A2-F57C-4A0C-AE32-2C3CD466259E}"/>
          </ac:picMkLst>
        </pc:picChg>
        <pc:picChg chg="add mod">
          <ac:chgData name="Tianxiao Chen" userId="138f6e53-1c63-40cd-bb43-399427c25ed2" providerId="ADAL" clId="{A8773628-DEB1-45C2-B77A-A6085D947177}" dt="2020-10-17T12:46:28.600" v="87" actId="1076"/>
          <ac:picMkLst>
            <pc:docMk/>
            <pc:sldMk cId="2811834353" sldId="276"/>
            <ac:picMk id="4" creationId="{384B34E5-C271-4F3B-8535-3F08DABD5643}"/>
          </ac:picMkLst>
        </pc:picChg>
        <pc:picChg chg="add del mod">
          <ac:chgData name="Tianxiao Chen" userId="138f6e53-1c63-40cd-bb43-399427c25ed2" providerId="ADAL" clId="{A8773628-DEB1-45C2-B77A-A6085D947177}" dt="2020-10-17T12:46:21.018" v="83" actId="478"/>
          <ac:picMkLst>
            <pc:docMk/>
            <pc:sldMk cId="2811834353" sldId="276"/>
            <ac:picMk id="5" creationId="{53A87A3B-F78A-4720-A2E4-5EB7EFBF0E70}"/>
          </ac:picMkLst>
        </pc:picChg>
      </pc:sldChg>
      <pc:sldChg chg="addSp delSp modSp">
        <pc:chgData name="Tianxiao Chen" userId="138f6e53-1c63-40cd-bb43-399427c25ed2" providerId="ADAL" clId="{A8773628-DEB1-45C2-B77A-A6085D947177}" dt="2020-10-17T12:45:47.806" v="76" actId="1076"/>
        <pc:sldMkLst>
          <pc:docMk/>
          <pc:sldMk cId="696762302" sldId="277"/>
        </pc:sldMkLst>
        <pc:spChg chg="del">
          <ac:chgData name="Tianxiao Chen" userId="138f6e53-1c63-40cd-bb43-399427c25ed2" providerId="ADAL" clId="{A8773628-DEB1-45C2-B77A-A6085D947177}" dt="2020-09-30T02:15:40.827" v="4" actId="478"/>
          <ac:spMkLst>
            <pc:docMk/>
            <pc:sldMk cId="696762302" sldId="277"/>
            <ac:spMk id="4" creationId="{70B9B4AF-9B8C-434E-8FF3-A3019C9007BF}"/>
          </ac:spMkLst>
        </pc:spChg>
        <pc:picChg chg="add del mod">
          <ac:chgData name="Tianxiao Chen" userId="138f6e53-1c63-40cd-bb43-399427c25ed2" providerId="ADAL" clId="{A8773628-DEB1-45C2-B77A-A6085D947177}" dt="2020-10-17T12:45:27.803" v="71" actId="478"/>
          <ac:picMkLst>
            <pc:docMk/>
            <pc:sldMk cId="696762302" sldId="277"/>
            <ac:picMk id="3" creationId="{CA8CA056-E3AE-43D1-9DC6-09C74B1A019C}"/>
          </ac:picMkLst>
        </pc:picChg>
        <pc:picChg chg="del">
          <ac:chgData name="Tianxiao Chen" userId="138f6e53-1c63-40cd-bb43-399427c25ed2" providerId="ADAL" clId="{A8773628-DEB1-45C2-B77A-A6085D947177}" dt="2020-09-30T02:15:39.550" v="3" actId="478"/>
          <ac:picMkLst>
            <pc:docMk/>
            <pc:sldMk cId="696762302" sldId="277"/>
            <ac:picMk id="3" creationId="{E6462CC4-F65C-41F9-94D2-F436DA109608}"/>
          </ac:picMkLst>
        </pc:picChg>
        <pc:picChg chg="add mod">
          <ac:chgData name="Tianxiao Chen" userId="138f6e53-1c63-40cd-bb43-399427c25ed2" providerId="ADAL" clId="{A8773628-DEB1-45C2-B77A-A6085D947177}" dt="2020-10-17T12:45:47.806" v="76" actId="1076"/>
          <ac:picMkLst>
            <pc:docMk/>
            <pc:sldMk cId="696762302" sldId="277"/>
            <ac:picMk id="5" creationId="{378B0D9A-143C-4748-A505-85DB7C20C697}"/>
          </ac:picMkLst>
        </pc:picChg>
      </pc:sldChg>
      <pc:sldChg chg="addSp delSp modSp add del">
        <pc:chgData name="Tianxiao Chen" userId="138f6e53-1c63-40cd-bb43-399427c25ed2" providerId="ADAL" clId="{A8773628-DEB1-45C2-B77A-A6085D947177}" dt="2020-10-17T12:46:51.182" v="93" actId="1076"/>
        <pc:sldMkLst>
          <pc:docMk/>
          <pc:sldMk cId="225929496" sldId="278"/>
        </pc:sldMkLst>
        <pc:spChg chg="del">
          <ac:chgData name="Tianxiao Chen" userId="138f6e53-1c63-40cd-bb43-399427c25ed2" providerId="ADAL" clId="{A8773628-DEB1-45C2-B77A-A6085D947177}" dt="2020-09-30T02:15:52.154" v="10" actId="478"/>
          <ac:spMkLst>
            <pc:docMk/>
            <pc:sldMk cId="225929496" sldId="278"/>
            <ac:spMk id="3" creationId="{AAB34F6C-7B82-4130-8BC5-8EF56D7A53DA}"/>
          </ac:spMkLst>
        </pc:spChg>
        <pc:picChg chg="del">
          <ac:chgData name="Tianxiao Chen" userId="138f6e53-1c63-40cd-bb43-399427c25ed2" providerId="ADAL" clId="{A8773628-DEB1-45C2-B77A-A6085D947177}" dt="2020-09-30T02:15:49.919" v="9" actId="478"/>
          <ac:picMkLst>
            <pc:docMk/>
            <pc:sldMk cId="225929496" sldId="278"/>
            <ac:picMk id="2" creationId="{D5508F63-B5DE-4BC4-A65B-BDD909DCB7C8}"/>
          </ac:picMkLst>
        </pc:picChg>
        <pc:picChg chg="add del mod">
          <ac:chgData name="Tianxiao Chen" userId="138f6e53-1c63-40cd-bb43-399427c25ed2" providerId="ADAL" clId="{A8773628-DEB1-45C2-B77A-A6085D947177}" dt="2020-10-05T07:18:37.055" v="45" actId="478"/>
          <ac:picMkLst>
            <pc:docMk/>
            <pc:sldMk cId="225929496" sldId="278"/>
            <ac:picMk id="3" creationId="{607E30FA-D8CD-4EC1-8C3F-7E47D7219735}"/>
          </ac:picMkLst>
        </pc:picChg>
        <pc:picChg chg="add mod">
          <ac:chgData name="Tianxiao Chen" userId="138f6e53-1c63-40cd-bb43-399427c25ed2" providerId="ADAL" clId="{A8773628-DEB1-45C2-B77A-A6085D947177}" dt="2020-10-05T11:27:30.021" v="56" actId="1076"/>
          <ac:picMkLst>
            <pc:docMk/>
            <pc:sldMk cId="225929496" sldId="278"/>
            <ac:picMk id="3" creationId="{B75D52B5-F519-4679-9614-E489BA92DE1B}"/>
          </ac:picMkLst>
        </pc:picChg>
        <pc:picChg chg="del">
          <ac:chgData name="Tianxiao Chen" userId="138f6e53-1c63-40cd-bb43-399427c25ed2" providerId="ADAL" clId="{A8773628-DEB1-45C2-B77A-A6085D947177}" dt="2020-10-17T12:46:32.547" v="88" actId="478"/>
          <ac:picMkLst>
            <pc:docMk/>
            <pc:sldMk cId="225929496" sldId="278"/>
            <ac:picMk id="4" creationId="{A30B8EAA-7268-45D2-9917-8BDFF24B40B0}"/>
          </ac:picMkLst>
        </pc:picChg>
        <pc:picChg chg="add mod">
          <ac:chgData name="Tianxiao Chen" userId="138f6e53-1c63-40cd-bb43-399427c25ed2" providerId="ADAL" clId="{A8773628-DEB1-45C2-B77A-A6085D947177}" dt="2020-10-17T12:46:51.182" v="93" actId="1076"/>
          <ac:picMkLst>
            <pc:docMk/>
            <pc:sldMk cId="225929496" sldId="278"/>
            <ac:picMk id="5" creationId="{82A1956E-61ED-45A1-BF37-EE93FEC6452D}"/>
          </ac:picMkLst>
        </pc:picChg>
        <pc:picChg chg="add del mod">
          <ac:chgData name="Tianxiao Chen" userId="138f6e53-1c63-40cd-bb43-399427c25ed2" providerId="ADAL" clId="{A8773628-DEB1-45C2-B77A-A6085D947177}" dt="2020-10-05T11:14:52.586" v="52" actId="478"/>
          <ac:picMkLst>
            <pc:docMk/>
            <pc:sldMk cId="225929496" sldId="278"/>
            <ac:picMk id="5" creationId="{F4CB80EE-4985-4A08-9435-29828F777919}"/>
          </ac:picMkLst>
        </pc:picChg>
      </pc:sldChg>
      <pc:sldChg chg="addSp delSp modSp">
        <pc:chgData name="Tianxiao Chen" userId="138f6e53-1c63-40cd-bb43-399427c25ed2" providerId="ADAL" clId="{A8773628-DEB1-45C2-B77A-A6085D947177}" dt="2020-10-17T12:46:10.646" v="82" actId="1076"/>
        <pc:sldMkLst>
          <pc:docMk/>
          <pc:sldMk cId="2798986350" sldId="279"/>
        </pc:sldMkLst>
        <pc:spChg chg="del">
          <ac:chgData name="Tianxiao Chen" userId="138f6e53-1c63-40cd-bb43-399427c25ed2" providerId="ADAL" clId="{A8773628-DEB1-45C2-B77A-A6085D947177}" dt="2020-09-30T02:15:44.275" v="6" actId="478"/>
          <ac:spMkLst>
            <pc:docMk/>
            <pc:sldMk cId="2798986350" sldId="279"/>
            <ac:spMk id="3" creationId="{E3049AF8-F132-4099-8FD1-3F9D896A635D}"/>
          </ac:spMkLst>
        </pc:spChg>
        <pc:picChg chg="del">
          <ac:chgData name="Tianxiao Chen" userId="138f6e53-1c63-40cd-bb43-399427c25ed2" providerId="ADAL" clId="{A8773628-DEB1-45C2-B77A-A6085D947177}" dt="2020-09-30T02:15:42.906" v="5" actId="478"/>
          <ac:picMkLst>
            <pc:docMk/>
            <pc:sldMk cId="2798986350" sldId="279"/>
            <ac:picMk id="2" creationId="{9B731F7E-8C6A-4455-94FC-B41491E9650C}"/>
          </ac:picMkLst>
        </pc:picChg>
        <pc:picChg chg="add del mod">
          <ac:chgData name="Tianxiao Chen" userId="138f6e53-1c63-40cd-bb43-399427c25ed2" providerId="ADAL" clId="{A8773628-DEB1-45C2-B77A-A6085D947177}" dt="2020-10-17T12:45:55.364" v="77" actId="478"/>
          <ac:picMkLst>
            <pc:docMk/>
            <pc:sldMk cId="2798986350" sldId="279"/>
            <ac:picMk id="3" creationId="{95F38A35-FC99-451D-A021-088CE5D25638}"/>
          </ac:picMkLst>
        </pc:picChg>
        <pc:picChg chg="add mod">
          <ac:chgData name="Tianxiao Chen" userId="138f6e53-1c63-40cd-bb43-399427c25ed2" providerId="ADAL" clId="{A8773628-DEB1-45C2-B77A-A6085D947177}" dt="2020-10-17T12:46:10.646" v="82" actId="1076"/>
          <ac:picMkLst>
            <pc:docMk/>
            <pc:sldMk cId="2798986350" sldId="279"/>
            <ac:picMk id="5" creationId="{9C6DA32E-5E77-4E07-9193-FF5D9561D95C}"/>
          </ac:picMkLst>
        </pc:picChg>
      </pc:sldChg>
      <pc:sldChg chg="del">
        <pc:chgData name="Tianxiao Chen" userId="138f6e53-1c63-40cd-bb43-399427c25ed2" providerId="ADAL" clId="{A8773628-DEB1-45C2-B77A-A6085D947177}" dt="2020-09-30T02:15:53.720" v="11" actId="2696"/>
        <pc:sldMkLst>
          <pc:docMk/>
          <pc:sldMk cId="2971242854" sldId="280"/>
        </pc:sldMkLst>
      </pc:sldChg>
      <pc:sldChg chg="del">
        <pc:chgData name="Tianxiao Chen" userId="138f6e53-1c63-40cd-bb43-399427c25ed2" providerId="ADAL" clId="{A8773628-DEB1-45C2-B77A-A6085D947177}" dt="2020-09-30T02:15:54.581" v="12" actId="2696"/>
        <pc:sldMkLst>
          <pc:docMk/>
          <pc:sldMk cId="2858326092" sldId="281"/>
        </pc:sldMkLst>
      </pc:sldChg>
      <pc:sldChg chg="del">
        <pc:chgData name="Tianxiao Chen" userId="138f6e53-1c63-40cd-bb43-399427c25ed2" providerId="ADAL" clId="{A8773628-DEB1-45C2-B77A-A6085D947177}" dt="2020-09-30T02:15:55.093" v="13" actId="2696"/>
        <pc:sldMkLst>
          <pc:docMk/>
          <pc:sldMk cId="4008080670" sldId="314"/>
        </pc:sldMkLst>
      </pc:sldChg>
      <pc:sldChg chg="del">
        <pc:chgData name="Tianxiao Chen" userId="138f6e53-1c63-40cd-bb43-399427c25ed2" providerId="ADAL" clId="{A8773628-DEB1-45C2-B77A-A6085D947177}" dt="2020-09-30T02:13:57.525" v="0" actId="2696"/>
        <pc:sldMkLst>
          <pc:docMk/>
          <pc:sldMk cId="1879458600" sldId="31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1072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80180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23953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1107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165760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61101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4077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69390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31619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30511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895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BADDA-CC5F-4735-B543-23A3921C03D6}" type="datetimeFigureOut">
              <a:rPr lang="en-AU" smtClean="0"/>
              <a:t>30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0266CB-A338-4767-854A-26B70739467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4789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ECBB316C-0F4B-4E11-AAAE-870375CB6B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6861" y="112542"/>
            <a:ext cx="6830277" cy="5978769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6AD13E5-C8D8-471A-84EE-D68B9D35A0EE}"/>
              </a:ext>
            </a:extLst>
          </p:cNvPr>
          <p:cNvSpPr/>
          <p:nvPr/>
        </p:nvSpPr>
        <p:spPr>
          <a:xfrm>
            <a:off x="1297743" y="6077244"/>
            <a:ext cx="668939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. S1 Comparison of LD decay in the whole population and the five major subgroups. The Y axis is the average </a:t>
            </a:r>
            <a:r>
              <a:rPr lang="en-US" sz="14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r</a:t>
            </a:r>
            <a:r>
              <a:rPr lang="en-US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r>
              <a:rPr lang="en-US" sz="1400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value of each 1 Mb region and the X axis is physical distance between markers in (unit of) Mb.</a:t>
            </a:r>
            <a:endParaRPr lang="en-AU" sz="1400" dirty="0"/>
          </a:p>
        </p:txBody>
      </p:sp>
    </p:spTree>
    <p:extLst>
      <p:ext uri="{BB962C8B-B14F-4D97-AF65-F5344CB8AC3E}">
        <p14:creationId xmlns:p14="http://schemas.microsoft.com/office/powerpoint/2010/main" val="10512261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B0D1FF84-23D9-4E85-915E-AEFAC4E62031}"/>
              </a:ext>
            </a:extLst>
          </p:cNvPr>
          <p:cNvSpPr/>
          <p:nvPr/>
        </p:nvSpPr>
        <p:spPr>
          <a:xfrm>
            <a:off x="907741" y="5894315"/>
            <a:ext cx="7328517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C The Manhattan and QQ plots for TGW, GL, GW and RLW of the basmati subgroup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E1E8B490-111C-436F-A9F7-78FC57461198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90080" y="68246"/>
            <a:ext cx="656384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19739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85FD69B7-1448-4F43-B3B1-2EB7743B8884}"/>
              </a:ext>
            </a:extLst>
          </p:cNvPr>
          <p:cNvSpPr/>
          <p:nvPr/>
        </p:nvSpPr>
        <p:spPr>
          <a:xfrm>
            <a:off x="787891" y="5930017"/>
            <a:ext cx="7568213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D The Manhattan and QQ plots for TGW, GL, GW and RLW of the </a:t>
            </a:r>
            <a:r>
              <a:rPr lang="en-US" altLang="zh-CN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x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ian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B0AD163A-7FBD-42CB-AA79-A2578C9395A5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00318" y="88223"/>
            <a:ext cx="654336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24907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796C1D43-FC74-4184-9A46-A648B63C835D}"/>
              </a:ext>
            </a:extLst>
          </p:cNvPr>
          <p:cNvSpPr/>
          <p:nvPr/>
        </p:nvSpPr>
        <p:spPr>
          <a:xfrm>
            <a:off x="535433" y="5907822"/>
            <a:ext cx="807313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E The Manhattan and QQ plots for TGW, GL, GW and RLW of the temperate</a:t>
            </a:r>
            <a:r>
              <a:rPr lang="en-US" sz="135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r>
              <a:rPr lang="en-US" altLang="zh-CN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C8DC2AD-C91E-4A37-B8B3-01FA3A5D997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10559" y="70443"/>
            <a:ext cx="652288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71391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941C3BDE-2875-4B55-B5F7-AAF242B0E6DB}"/>
              </a:ext>
            </a:extLst>
          </p:cNvPr>
          <p:cNvSpPr/>
          <p:nvPr/>
        </p:nvSpPr>
        <p:spPr>
          <a:xfrm>
            <a:off x="535433" y="5907822"/>
            <a:ext cx="807313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F The Manhattan and QQ plots for TGW, GL, GW and RLW of the tropical </a:t>
            </a:r>
            <a:r>
              <a:rPr lang="en-US" altLang="zh-CN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35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subgroup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0AB0D3D-E558-4293-8C8A-2DF4FE5FAA7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10559" y="76015"/>
            <a:ext cx="652288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03194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A674B2E3-38CC-4DB9-A24C-A4F84D3DAB8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00317" y="85979"/>
            <a:ext cx="6543360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DF5E3B78-AFA9-486C-A964-49CDCB638380}"/>
              </a:ext>
            </a:extLst>
          </p:cNvPr>
          <p:cNvSpPr/>
          <p:nvPr/>
        </p:nvSpPr>
        <p:spPr>
          <a:xfrm>
            <a:off x="1166323" y="5924254"/>
            <a:ext cx="6811348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A The Manhattan and QQ plots for TGW, GL, GW and RLW of the whole population in 2017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265142991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59DCE731-2D78-43CA-B249-DDFF1D80EF2F}"/>
              </a:ext>
            </a:extLst>
          </p:cNvPr>
          <p:cNvSpPr/>
          <p:nvPr/>
        </p:nvSpPr>
        <p:spPr>
          <a:xfrm>
            <a:off x="1060880" y="5927606"/>
            <a:ext cx="7022237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B The Manhattan and QQ plots for TGW, GL, GW and RLW of the </a:t>
            </a:r>
            <a:r>
              <a:rPr lang="en-US" sz="1350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aus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7</a:t>
            </a:r>
            <a:endParaRPr lang="en-AU" sz="1350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6E253B7-5018-4F96-B7B0-CB7B2AAB3C09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9" y="71021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302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B0D1FF84-23D9-4E85-915E-AEFAC4E62031}"/>
              </a:ext>
            </a:extLst>
          </p:cNvPr>
          <p:cNvSpPr/>
          <p:nvPr/>
        </p:nvSpPr>
        <p:spPr>
          <a:xfrm>
            <a:off x="737954" y="5912071"/>
            <a:ext cx="766808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C The Manhattan and QQ plots for TGW, GL, GW and RLW of the basmati subgroup in 2017</a:t>
            </a:r>
            <a:endParaRPr lang="en-AU" sz="14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DCF41B2-F790-4553-AE2A-2453EFA111DA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9" y="79899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18725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85FD69B7-1448-4F43-B3B1-2EB7743B8884}"/>
              </a:ext>
            </a:extLst>
          </p:cNvPr>
          <p:cNvSpPr/>
          <p:nvPr/>
        </p:nvSpPr>
        <p:spPr>
          <a:xfrm>
            <a:off x="787890" y="5903383"/>
            <a:ext cx="756821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D The Manhattan and QQ plots for TGW, GL, GW and RLW of the </a:t>
            </a:r>
            <a:r>
              <a:rPr lang="en-US" altLang="zh-CN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x</a:t>
            </a:r>
            <a:r>
              <a:rPr lang="en-US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ian</a:t>
            </a:r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7</a:t>
            </a:r>
            <a:endParaRPr lang="en-AU" sz="14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0CAD0DD8-D7DB-4195-B8F5-66547AD589C3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7" y="62144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548351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796C1D43-FC74-4184-9A46-A648B63C835D}"/>
              </a:ext>
            </a:extLst>
          </p:cNvPr>
          <p:cNvSpPr/>
          <p:nvPr/>
        </p:nvSpPr>
        <p:spPr>
          <a:xfrm>
            <a:off x="392001" y="5907823"/>
            <a:ext cx="835999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E The Manhattan and QQ plots for TGW, GL, GW and RLW of the temperate </a:t>
            </a:r>
            <a:r>
              <a:rPr lang="en-US" altLang="zh-CN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7</a:t>
            </a:r>
            <a:endParaRPr lang="en-AU" sz="14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28070A6-4E2F-4452-A309-BB0D3C2211F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8" y="71021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830964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941C3BDE-2875-4B55-B5F7-AAF242B0E6DB}"/>
              </a:ext>
            </a:extLst>
          </p:cNvPr>
          <p:cNvSpPr/>
          <p:nvPr/>
        </p:nvSpPr>
        <p:spPr>
          <a:xfrm>
            <a:off x="489655" y="5898944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4F The Manhattan and QQ plots for TGW, GL, GW and RLW of the tropical </a:t>
            </a:r>
            <a:r>
              <a:rPr lang="en-US" altLang="zh-CN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40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7</a:t>
            </a:r>
            <a:endParaRPr lang="en-AU" sz="14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B2239C1-258A-409C-9095-EDFD2FA817D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8" y="71022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765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08360D8-A2B5-481B-8EAF-8DBFA1DF3E6D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14574" y="197161"/>
            <a:ext cx="6615042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DF5E3B78-AFA9-486C-A964-49CDCB638380}"/>
              </a:ext>
            </a:extLst>
          </p:cNvPr>
          <p:cNvSpPr/>
          <p:nvPr/>
        </p:nvSpPr>
        <p:spPr>
          <a:xfrm>
            <a:off x="1039657" y="5957161"/>
            <a:ext cx="7164876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A </a:t>
            </a:r>
            <a:r>
              <a:rPr lang="en-US" altLang="zh-CN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The</a:t>
            </a:r>
            <a:r>
              <a:rPr lang="zh-CN" alt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Manhattan and QQ plots for TGW, GL, GW and RLW </a:t>
            </a:r>
            <a:r>
              <a:rPr lang="en-US" altLang="zh-CN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of</a:t>
            </a:r>
            <a:r>
              <a:rPr lang="zh-CN" alt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the whole population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13578715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9C3DB38-190F-4018-B01B-373CFF438A4B}"/>
              </a:ext>
            </a:extLst>
          </p:cNvPr>
          <p:cNvSpPr txBox="1"/>
          <p:nvPr/>
        </p:nvSpPr>
        <p:spPr>
          <a:xfrm>
            <a:off x="150828" y="5685478"/>
            <a:ext cx="8842343" cy="95410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400">
                <a:latin typeface="Times New Roman" panose="02020603050405020304" pitchFamily="18" charset="0"/>
                <a:ea typeface="微软雅黑" panose="020B0503020204020204" pitchFamily="34" charset="-122"/>
              </a:defRPr>
            </a:lvl1pPr>
          </a:lstStyle>
          <a:p>
            <a:pPr algn="just"/>
            <a:r>
              <a:rPr lang="en-US" altLang="zh-CN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5 </a:t>
            </a:r>
            <a:r>
              <a:rPr lang="en-US" altLang="zh-CN" dirty="0"/>
              <a:t>(a) High-density association analysis of </a:t>
            </a:r>
            <a:r>
              <a:rPr lang="en-US" altLang="zh-CN" i="1" dirty="0"/>
              <a:t>qTGW9</a:t>
            </a:r>
            <a:r>
              <a:rPr lang="en-US" altLang="zh-CN" dirty="0"/>
              <a:t> in 2015, 2016, and 2017. The solid line indicates the threshold to determine significant SNP. (b-c) Gene structural of candidate gene </a:t>
            </a:r>
            <a:r>
              <a:rPr lang="en-US" altLang="zh-CN" i="1" dirty="0"/>
              <a:t>Os09g0544400</a:t>
            </a:r>
            <a:r>
              <a:rPr lang="en-US" altLang="zh-CN" dirty="0"/>
              <a:t> and haplotype analysis for TGW in the whole population and the 12 subgroups. Characters on top of boxplots indicate significant differences based on Duncan’s multiple comparison tests (P &lt; 0.05)</a:t>
            </a:r>
            <a:endParaRPr lang="zh-CN" altLang="en-US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6A18C21-5224-4352-BAF2-C3B290F078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7715" y="3420"/>
            <a:ext cx="7195854" cy="5753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55193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871BDF7-84C7-482D-B841-52F0C14040E0}"/>
              </a:ext>
            </a:extLst>
          </p:cNvPr>
          <p:cNvSpPr txBox="1"/>
          <p:nvPr/>
        </p:nvSpPr>
        <p:spPr>
          <a:xfrm>
            <a:off x="207388" y="5670125"/>
            <a:ext cx="8729221" cy="95410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defRPr sz="1400">
                <a:latin typeface="Times New Roman" panose="02020603050405020304" pitchFamily="18" charset="0"/>
                <a:ea typeface="微软雅黑" panose="020B0503020204020204" pitchFamily="34" charset="-122"/>
              </a:defRPr>
            </a:lvl1pPr>
          </a:lstStyle>
          <a:p>
            <a:r>
              <a:rPr lang="en-US" altLang="zh-CN" dirty="0"/>
              <a:t>Fig. S6 (a) High-density association analysis of </a:t>
            </a:r>
            <a:r>
              <a:rPr lang="en-US" altLang="zh-CN" i="1" dirty="0"/>
              <a:t>qTGW11</a:t>
            </a:r>
            <a:r>
              <a:rPr lang="en-US" altLang="zh-CN" dirty="0"/>
              <a:t> in 2015, 2016, and 2017. The solid line indicates the threshold to determine significant SNP. (b-c) Gene structural of candidate gene </a:t>
            </a:r>
            <a:r>
              <a:rPr lang="en-US" altLang="zh-CN" i="1" dirty="0"/>
              <a:t>Os11g0163600</a:t>
            </a:r>
            <a:r>
              <a:rPr lang="en-US" altLang="zh-CN" dirty="0"/>
              <a:t> and haplotype analysis for TGW in the whole population and the 12 subgroups. Characters on top of boxplots indicate significant differences based on Duncan’s multiple comparison tests (P &lt; 0.05)</a:t>
            </a:r>
            <a:endParaRPr lang="zh-CN" altLang="en-US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5FB47EE-D918-43E9-B057-B5DE562F7D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6929" y="59076"/>
            <a:ext cx="7130138" cy="5670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96895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9B1771C-B16C-484C-A4A8-D6FFBF958C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7084" y="54204"/>
            <a:ext cx="6929832" cy="52627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D137CB9-5D1E-4724-A1D9-41AF6DC60687}"/>
              </a:ext>
            </a:extLst>
          </p:cNvPr>
          <p:cNvSpPr txBox="1"/>
          <p:nvPr/>
        </p:nvSpPr>
        <p:spPr>
          <a:xfrm>
            <a:off x="160256" y="5531625"/>
            <a:ext cx="8823488" cy="95410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defRPr sz="1400">
                <a:latin typeface="Times New Roman" panose="02020603050405020304" pitchFamily="18" charset="0"/>
                <a:ea typeface="微软雅黑" panose="020B0503020204020204" pitchFamily="34" charset="-122"/>
              </a:defRPr>
            </a:lvl1pPr>
          </a:lstStyle>
          <a:p>
            <a:r>
              <a:rPr lang="en-US" altLang="zh-CN" dirty="0"/>
              <a:t>Fig. S7 (a) High-density association analysis of </a:t>
            </a:r>
            <a:r>
              <a:rPr lang="en-US" altLang="zh-CN" i="1" dirty="0"/>
              <a:t>qGL10</a:t>
            </a:r>
            <a:r>
              <a:rPr lang="en-US" altLang="zh-CN" dirty="0"/>
              <a:t> in 2015, 2016, and 2017. The solid line indicates the threshold to determine significant SNP. (b‒c) Gene structural of candidate genes </a:t>
            </a:r>
            <a:r>
              <a:rPr lang="en-US" altLang="zh-CN" i="1" dirty="0"/>
              <a:t>Os10g0399700</a:t>
            </a:r>
            <a:r>
              <a:rPr lang="en-US" altLang="zh-CN" dirty="0"/>
              <a:t> and </a:t>
            </a:r>
            <a:r>
              <a:rPr lang="en-US" altLang="zh-CN" i="1" dirty="0"/>
              <a:t>Os10g0400100</a:t>
            </a:r>
            <a:r>
              <a:rPr lang="en-US" altLang="zh-CN" dirty="0"/>
              <a:t>, and haplotype analyses for GL in the whole population and the 12 subgroups. Characters on top of boxplots indicate significant differences based on Duncan’s multiple comparison tests (P &lt; 0.05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3092608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4F67D40D-C18F-4977-B5A2-0EEF4D5F4E2E}"/>
              </a:ext>
            </a:extLst>
          </p:cNvPr>
          <p:cNvSpPr/>
          <p:nvPr/>
        </p:nvSpPr>
        <p:spPr>
          <a:xfrm>
            <a:off x="489657" y="6540321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8 Haplotypes analysis of  </a:t>
            </a:r>
            <a:r>
              <a:rPr lang="en-US" sz="140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GS3</a:t>
            </a:r>
            <a:endParaRPr lang="en-AU" sz="1400" i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C9202AF-0C08-4CEC-8A4A-E79787627E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974" y="0"/>
            <a:ext cx="8640051" cy="6540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564691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C3974F62-3C31-4E36-B00B-707DEC153221}"/>
              </a:ext>
            </a:extLst>
          </p:cNvPr>
          <p:cNvSpPr/>
          <p:nvPr/>
        </p:nvSpPr>
        <p:spPr>
          <a:xfrm>
            <a:off x="489657" y="6465165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9 Haplotypes analysis of  </a:t>
            </a:r>
            <a:r>
              <a:rPr lang="en-US" sz="140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GW5</a:t>
            </a:r>
            <a:endParaRPr lang="en-AU" sz="1400" i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BBF7954-F513-4AB7-9C1D-9C266934D1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0829" y="0"/>
            <a:ext cx="8022339" cy="6465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676230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6D259019-01DF-4B5F-B14C-698C3A436E64}"/>
              </a:ext>
            </a:extLst>
          </p:cNvPr>
          <p:cNvSpPr/>
          <p:nvPr/>
        </p:nvSpPr>
        <p:spPr>
          <a:xfrm>
            <a:off x="489657" y="6465165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10 Haplotypes analysis of  </a:t>
            </a:r>
            <a:r>
              <a:rPr lang="en-US" sz="140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GL7</a:t>
            </a:r>
            <a:endParaRPr lang="en-AU" sz="1400" i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E91BC3F-5E7D-4845-ADEE-487437B926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023" y="0"/>
            <a:ext cx="8073951" cy="6387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986350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0E7D17BB-E507-4316-AF34-7799D1C3EF72}"/>
              </a:ext>
            </a:extLst>
          </p:cNvPr>
          <p:cNvSpPr/>
          <p:nvPr/>
        </p:nvSpPr>
        <p:spPr>
          <a:xfrm>
            <a:off x="489657" y="6465165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11 Haplotypes analysis of  </a:t>
            </a:r>
            <a:r>
              <a:rPr lang="en-US" sz="140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FZP</a:t>
            </a:r>
            <a:endParaRPr lang="en-AU" sz="1400" i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8087908-1F6C-4212-9514-C96FD5D861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35122"/>
            <a:ext cx="9144000" cy="61877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183435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41F130F1-DC01-4EA5-801E-02620907D3CA}"/>
              </a:ext>
            </a:extLst>
          </p:cNvPr>
          <p:cNvSpPr/>
          <p:nvPr/>
        </p:nvSpPr>
        <p:spPr>
          <a:xfrm>
            <a:off x="489657" y="6465165"/>
            <a:ext cx="816468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12 Haplotypes analysis of  </a:t>
            </a:r>
            <a:r>
              <a:rPr lang="en-US" sz="1400" i="1" dirty="0">
                <a:latin typeface="Times New Roman" panose="02020603050405020304" pitchFamily="18" charset="0"/>
                <a:ea typeface="微软雅黑" panose="020B0503020204020204" pitchFamily="34" charset="-122"/>
              </a:rPr>
              <a:t>GW8</a:t>
            </a:r>
            <a:endParaRPr lang="en-AU" sz="1400" i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11D9C32-2BE2-44F5-9D6A-464F1E172E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308" y="0"/>
            <a:ext cx="8217382" cy="6465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29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8AC2648-ABBA-478F-9220-D993E0FA4A7C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10560" y="80454"/>
            <a:ext cx="6522880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59DCE731-2D78-43CA-B249-DDFF1D80EF2F}"/>
              </a:ext>
            </a:extLst>
          </p:cNvPr>
          <p:cNvSpPr/>
          <p:nvPr/>
        </p:nvSpPr>
        <p:spPr>
          <a:xfrm>
            <a:off x="1060881" y="5954240"/>
            <a:ext cx="7022237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B The Manhattan and QQ plots for TGW, GL, GW and RLW of the </a:t>
            </a:r>
            <a:r>
              <a:rPr lang="en-US" sz="1350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aus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13151334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57324DD-B3AF-4589-B71A-C4BF999B2BFA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20800" y="98208"/>
            <a:ext cx="6502400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B0D1FF84-23D9-4E85-915E-AEFAC4E62031}"/>
              </a:ext>
            </a:extLst>
          </p:cNvPr>
          <p:cNvSpPr/>
          <p:nvPr/>
        </p:nvSpPr>
        <p:spPr>
          <a:xfrm>
            <a:off x="907741" y="5947583"/>
            <a:ext cx="7328517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C The Manhattan and QQ plots for TGW, GL, GW and RLW of the basmati subgroup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21242862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5CDE186-706C-4870-8CD0-B6179CD3C12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6158" y="73796"/>
            <a:ext cx="6471681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85FD69B7-1448-4F43-B3B1-2EB7743B8884}"/>
              </a:ext>
            </a:extLst>
          </p:cNvPr>
          <p:cNvSpPr/>
          <p:nvPr/>
        </p:nvSpPr>
        <p:spPr>
          <a:xfrm>
            <a:off x="787891" y="5925577"/>
            <a:ext cx="7568213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D The Manhattan and QQ plots for TGW, GL, GW and RLW of the 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xian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9994368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7482267-A252-4931-8ABF-962375F6652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61758" y="82674"/>
            <a:ext cx="6420481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796C1D43-FC74-4184-9A46-A648B63C835D}"/>
              </a:ext>
            </a:extLst>
          </p:cNvPr>
          <p:cNvSpPr/>
          <p:nvPr/>
        </p:nvSpPr>
        <p:spPr>
          <a:xfrm>
            <a:off x="535432" y="5969966"/>
            <a:ext cx="807313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E The Manhattan and QQ plots for TGW, GL, GW and RLW of the temperate </a:t>
            </a:r>
            <a:r>
              <a:rPr lang="en-US" altLang="zh-CN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1135191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12DBA4A-AECD-4CB8-A78B-B98F706EAD1C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90079" y="64918"/>
            <a:ext cx="6563840" cy="57600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941C3BDE-2875-4B55-B5F7-AAF242B0E6DB}"/>
              </a:ext>
            </a:extLst>
          </p:cNvPr>
          <p:cNvSpPr/>
          <p:nvPr/>
        </p:nvSpPr>
        <p:spPr>
          <a:xfrm>
            <a:off x="535433" y="5898944"/>
            <a:ext cx="807313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2F The Manhattan and QQ plots for TGW, GL, GW and RLW of the tropical </a:t>
            </a:r>
            <a:r>
              <a:rPr lang="en-US" altLang="zh-CN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g</a:t>
            </a:r>
            <a:r>
              <a:rPr lang="en-US" sz="1350" i="1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eng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5</a:t>
            </a:r>
            <a:endParaRPr lang="en-AU" sz="1350" dirty="0"/>
          </a:p>
        </p:txBody>
      </p:sp>
    </p:spTree>
    <p:extLst>
      <p:ext uri="{BB962C8B-B14F-4D97-AF65-F5344CB8AC3E}">
        <p14:creationId xmlns:p14="http://schemas.microsoft.com/office/powerpoint/2010/main" val="14730036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DF5E3B78-AFA9-486C-A964-49CDCB638380}"/>
              </a:ext>
            </a:extLst>
          </p:cNvPr>
          <p:cNvSpPr/>
          <p:nvPr/>
        </p:nvSpPr>
        <p:spPr>
          <a:xfrm>
            <a:off x="1028849" y="5915376"/>
            <a:ext cx="6811348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A The Manhattan and QQ plots for TGW, GL, GW and RLW of the whole population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EF1CD2CF-430B-4EBC-B6F8-85109EAF309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036" y="86488"/>
            <a:ext cx="648192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65677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>
            <a:extLst>
              <a:ext uri="{FF2B5EF4-FFF2-40B4-BE49-F238E27FC236}">
                <a16:creationId xmlns:a16="http://schemas.microsoft.com/office/drawing/2014/main" id="{59DCE731-2D78-43CA-B249-DDFF1D80EF2F}"/>
              </a:ext>
            </a:extLst>
          </p:cNvPr>
          <p:cNvSpPr/>
          <p:nvPr/>
        </p:nvSpPr>
        <p:spPr>
          <a:xfrm>
            <a:off x="1060881" y="5892096"/>
            <a:ext cx="7022237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Fig. S3B The Manhattan and QQ plots for TGW, GL, GW and RLW of the </a:t>
            </a:r>
            <a:r>
              <a:rPr lang="en-US" sz="1350" dirty="0" err="1">
                <a:latin typeface="Times New Roman" panose="02020603050405020304" pitchFamily="18" charset="0"/>
                <a:ea typeface="微软雅黑" panose="020B0503020204020204" pitchFamily="34" charset="-122"/>
              </a:rPr>
              <a:t>aus</a:t>
            </a:r>
            <a:r>
              <a:rPr lang="en-US" sz="1350" dirty="0">
                <a:latin typeface="Times New Roman" panose="02020603050405020304" pitchFamily="18" charset="0"/>
                <a:ea typeface="微软雅黑" panose="020B0503020204020204" pitchFamily="34" charset="-122"/>
              </a:rPr>
              <a:t> subgroup in 2016</a:t>
            </a:r>
            <a:endParaRPr lang="en-AU" sz="1350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CEF0B60-6611-42C8-85B4-C4EEC34BD47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84960" y="68248"/>
            <a:ext cx="657408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31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5</TotalTime>
  <Words>704</Words>
  <Application>Microsoft Office PowerPoint</Application>
  <PresentationFormat>On-screen Show (4:3)</PresentationFormat>
  <Paragraphs>27</Paragraphs>
  <Slides>2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ianxiao Chen</dc:creator>
  <cp:lastModifiedBy>Tianxiao Chen</cp:lastModifiedBy>
  <cp:revision>40</cp:revision>
  <dcterms:created xsi:type="dcterms:W3CDTF">2020-02-03T22:39:44Z</dcterms:created>
  <dcterms:modified xsi:type="dcterms:W3CDTF">2021-03-30T06:48:04Z</dcterms:modified>
</cp:coreProperties>
</file>